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7"/>
  </p:notesMasterIdLst>
  <p:sldIdLst>
    <p:sldId id="277" r:id="rId2"/>
    <p:sldId id="256" r:id="rId3"/>
    <p:sldId id="257" r:id="rId4"/>
    <p:sldId id="259" r:id="rId5"/>
    <p:sldId id="260" r:id="rId6"/>
    <p:sldId id="276" r:id="rId7"/>
    <p:sldId id="261" r:id="rId8"/>
    <p:sldId id="262" r:id="rId9"/>
    <p:sldId id="275" r:id="rId10"/>
    <p:sldId id="263" r:id="rId11"/>
    <p:sldId id="272" r:id="rId12"/>
    <p:sldId id="274" r:id="rId13"/>
    <p:sldId id="264" r:id="rId14"/>
    <p:sldId id="265" r:id="rId15"/>
    <p:sldId id="266" r:id="rId1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>
      <p:cViewPr varScale="1">
        <p:scale>
          <a:sx n="85" d="100"/>
          <a:sy n="85" d="100"/>
        </p:scale>
        <p:origin x="5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3921CD-76FE-4D05-BD53-5C6E99809261}" type="datetimeFigureOut">
              <a:rPr lang="zh-CN" altLang="en-US" smtClean="0"/>
              <a:t>2022/9/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5A38B0-EE59-4D2A-9E93-92EBADAF1A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98698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5A38B0-EE59-4D2A-9E93-92EBADAF1AAD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02260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570B327-5B8A-8E47-50DA-A74C9453A5F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050C7C1-6405-3E15-ADD0-D517512C42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BD8A8DD-510A-0AAE-BCBB-B30BE263D1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B7E52-8405-4883-BEA3-6B70B68A1A1A}" type="datetimeFigureOut">
              <a:rPr lang="zh-CN" altLang="en-US" smtClean="0"/>
              <a:t>2022/9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3162F81-EE59-84FF-2ECC-8AE99BFB69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591DF6-29C5-4554-EC98-940B221ABB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A3EDE-2A28-48D8-A515-D4AB593E4B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1816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BFF1C1-A730-12B9-216B-C382D3B605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F4566D3-35FB-E22E-63FC-241B8189E4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163BDB6-7FE1-B425-B87C-6390BBCCD9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B7E52-8405-4883-BEA3-6B70B68A1A1A}" type="datetimeFigureOut">
              <a:rPr lang="zh-CN" altLang="en-US" smtClean="0"/>
              <a:t>2022/9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2B70256-6DA5-1BA5-1D72-B637BB6EFD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6908F6-A64A-F58B-84BE-A48E4AE797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A3EDE-2A28-48D8-A515-D4AB593E4B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4633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E008E99-5FF7-5CE7-427F-84AFD281DC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6F9E142-E061-19C3-AF79-B47B25DDA3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3485E7-F231-913C-8F61-9A3E6B55C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B7E52-8405-4883-BEA3-6B70B68A1A1A}" type="datetimeFigureOut">
              <a:rPr lang="zh-CN" altLang="en-US" smtClean="0"/>
              <a:t>2022/9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A181617-28F7-B195-1BAA-7995471705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B6F356E-0551-3A47-A45A-36CDD31CC7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A3EDE-2A28-48D8-A515-D4AB593E4B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8902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F03B43E-41CC-7CC1-FAD7-9B6F1654D3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D76BE63-7920-AF8D-1077-C0AC75FC64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88F6FAA-53B4-974D-D663-F4367F45B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B7E52-8405-4883-BEA3-6B70B68A1A1A}" type="datetimeFigureOut">
              <a:rPr lang="zh-CN" altLang="en-US" smtClean="0"/>
              <a:t>2022/9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2FB942-EE2B-AD0E-E696-05F22F538A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7045414-0F9A-49C5-E096-DE3FE8C38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A3EDE-2A28-48D8-A515-D4AB593E4B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16844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7DEDD8-41A5-B1B2-B5E4-AB5BFD7EF8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647D097-834F-B38B-8575-84E98006B0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1C52D6A-98CE-80D2-D2A2-742A516DB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B7E52-8405-4883-BEA3-6B70B68A1A1A}" type="datetimeFigureOut">
              <a:rPr lang="zh-CN" altLang="en-US" smtClean="0"/>
              <a:t>2022/9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CD1EC8C-8D1A-E4C9-90A5-56A139E2C2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BC3F780-197A-3A5A-5397-EA873D2943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A3EDE-2A28-48D8-A515-D4AB593E4B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0301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AA6670F-E1C1-A095-CFD1-EC0AD42311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6D774FA-A75E-C8F0-EEB8-6BA0F6F6CD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9428D2E-91BE-F4B5-693A-21941E1E77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2A1C6F4-18F3-AF8B-7450-61791CBCD4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B7E52-8405-4883-BEA3-6B70B68A1A1A}" type="datetimeFigureOut">
              <a:rPr lang="zh-CN" altLang="en-US" smtClean="0"/>
              <a:t>2022/9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B7B5E1C-322B-9986-772C-D9A2B0D32B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B26FBBF-FC5D-C6BE-91CE-FBCD0C0E95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A3EDE-2A28-48D8-A515-D4AB593E4B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1562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F3D1478-B1BE-90DF-E0BB-8360259151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FD77BC4-FEF9-C8FD-8DD8-7FB50C0EAC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29D3B2E-E571-8CB9-9B45-4DCD4885D7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63D6467-3CED-2E71-134A-D0444E941F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0396C55-E390-3204-DE4B-AA8154E6AA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0E1CDE2-C728-D4AF-64E0-97D436FD0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B7E52-8405-4883-BEA3-6B70B68A1A1A}" type="datetimeFigureOut">
              <a:rPr lang="zh-CN" altLang="en-US" smtClean="0"/>
              <a:t>2022/9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2533EE5-8E91-4056-E1A4-C590444A88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E8425E3-CDA0-1ED7-076E-388EFFD1C7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A3EDE-2A28-48D8-A515-D4AB593E4B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32248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9821996-00AB-C11B-581C-793999CD89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A01B776-60BD-6FFB-B11E-BE60476715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B7E52-8405-4883-BEA3-6B70B68A1A1A}" type="datetimeFigureOut">
              <a:rPr lang="zh-CN" altLang="en-US" smtClean="0"/>
              <a:t>2022/9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D302853-01A6-ED1B-29CE-843CF76A77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1B8880E-4ABC-3E08-BDBC-786D4A99F2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A3EDE-2A28-48D8-A515-D4AB593E4B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9244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5A366B3-796E-3D0C-AB27-FA20120E43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B7E52-8405-4883-BEA3-6B70B68A1A1A}" type="datetimeFigureOut">
              <a:rPr lang="zh-CN" altLang="en-US" smtClean="0"/>
              <a:t>2022/9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B6FCF6F-84AC-4091-8470-21A1E4166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4CB7AB5-0893-195E-2E47-A1CDEA59DC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A3EDE-2A28-48D8-A515-D4AB593E4B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7486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F69940-AEE2-F359-AE2D-AAE62F97E5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AF6050B-3EB4-A177-C882-1B907377E6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3289C71-3752-BC1A-FFAA-8A85974A00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BC373F0-19EA-A8DE-8696-3E61EB9F32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B7E52-8405-4883-BEA3-6B70B68A1A1A}" type="datetimeFigureOut">
              <a:rPr lang="zh-CN" altLang="en-US" smtClean="0"/>
              <a:t>2022/9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A861972-3E1F-F6BE-2051-F2EF1491EF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F2F81F8-5B3D-0F82-B49A-CE2746B07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A3EDE-2A28-48D8-A515-D4AB593E4B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4824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C9E8EA-4B7D-9C46-5262-18B0B77ACD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0799BD4-198E-B354-1BF3-431729516A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420E325-93DA-E02D-8F3E-F8F0EE5C16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FC06C63-9570-FB2E-B01A-31EDAC2A0A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B7E52-8405-4883-BEA3-6B70B68A1A1A}" type="datetimeFigureOut">
              <a:rPr lang="zh-CN" altLang="en-US" smtClean="0"/>
              <a:t>2022/9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5D01AB9-0AB6-D08B-9FE6-4548170969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8816235-DED7-C849-8EFE-A6D6B6A503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A3EDE-2A28-48D8-A515-D4AB593E4B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3572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D71818C-2CC2-9510-4A6A-E4BD66DFF0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7AF91C6-571A-41F1-349A-8C25BE81C7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CEB954F-56EF-6942-AD02-306B10191C9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1B7E52-8405-4883-BEA3-6B70B68A1A1A}" type="datetimeFigureOut">
              <a:rPr lang="zh-CN" altLang="en-US" smtClean="0"/>
              <a:t>2022/9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AAA04ED-EA72-DE22-DC61-93A7EFE81B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658933D-1D5C-7D73-7C6E-EFF45B7C110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8A3EDE-2A28-48D8-A515-D4AB593E4B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29815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1.png"/><Relationship Id="rId2" Type="http://schemas.openxmlformats.org/officeDocument/2006/relationships/image" Target="../media/image12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3.png"/><Relationship Id="rId4" Type="http://schemas.openxmlformats.org/officeDocument/2006/relationships/image" Target="../media/image122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0.png"/><Relationship Id="rId13" Type="http://schemas.openxmlformats.org/officeDocument/2006/relationships/image" Target="../media/image135.png"/><Relationship Id="rId3" Type="http://schemas.openxmlformats.org/officeDocument/2006/relationships/image" Target="../media/image125.png"/><Relationship Id="rId7" Type="http://schemas.openxmlformats.org/officeDocument/2006/relationships/image" Target="../media/image129.png"/><Relationship Id="rId12" Type="http://schemas.openxmlformats.org/officeDocument/2006/relationships/image" Target="../media/image134.png"/><Relationship Id="rId2" Type="http://schemas.openxmlformats.org/officeDocument/2006/relationships/image" Target="../media/image12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8.png"/><Relationship Id="rId11" Type="http://schemas.openxmlformats.org/officeDocument/2006/relationships/image" Target="../media/image133.png"/><Relationship Id="rId5" Type="http://schemas.openxmlformats.org/officeDocument/2006/relationships/image" Target="../media/image127.png"/><Relationship Id="rId10" Type="http://schemas.openxmlformats.org/officeDocument/2006/relationships/image" Target="../media/image132.png"/><Relationship Id="rId4" Type="http://schemas.openxmlformats.org/officeDocument/2006/relationships/image" Target="../media/image126.png"/><Relationship Id="rId9" Type="http://schemas.openxmlformats.org/officeDocument/2006/relationships/image" Target="../media/image131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1.png"/><Relationship Id="rId13" Type="http://schemas.microsoft.com/office/2007/relationships/hdphoto" Target="../media/hdphoto4.wdp"/><Relationship Id="rId3" Type="http://schemas.openxmlformats.org/officeDocument/2006/relationships/image" Target="../media/image137.png"/><Relationship Id="rId7" Type="http://schemas.openxmlformats.org/officeDocument/2006/relationships/image" Target="../media/image140.png"/><Relationship Id="rId12" Type="http://schemas.openxmlformats.org/officeDocument/2006/relationships/image" Target="../media/image145.png"/><Relationship Id="rId2" Type="http://schemas.openxmlformats.org/officeDocument/2006/relationships/image" Target="../media/image136.png"/><Relationship Id="rId1" Type="http://schemas.openxmlformats.org/officeDocument/2006/relationships/slideLayout" Target="../slideLayouts/slideLayout7.xml"/><Relationship Id="rId6" Type="http://schemas.microsoft.com/office/2007/relationships/hdphoto" Target="../media/hdphoto3.wdp"/><Relationship Id="rId11" Type="http://schemas.openxmlformats.org/officeDocument/2006/relationships/image" Target="../media/image144.png"/><Relationship Id="rId5" Type="http://schemas.openxmlformats.org/officeDocument/2006/relationships/image" Target="../media/image139.png"/><Relationship Id="rId15" Type="http://schemas.openxmlformats.org/officeDocument/2006/relationships/image" Target="../media/image147.png"/><Relationship Id="rId10" Type="http://schemas.openxmlformats.org/officeDocument/2006/relationships/image" Target="../media/image143.png"/><Relationship Id="rId4" Type="http://schemas.openxmlformats.org/officeDocument/2006/relationships/image" Target="../media/image138.png"/><Relationship Id="rId9" Type="http://schemas.openxmlformats.org/officeDocument/2006/relationships/image" Target="../media/image142.png"/><Relationship Id="rId14" Type="http://schemas.openxmlformats.org/officeDocument/2006/relationships/image" Target="../media/image146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3.png"/><Relationship Id="rId13" Type="http://schemas.openxmlformats.org/officeDocument/2006/relationships/image" Target="../media/image158.png"/><Relationship Id="rId18" Type="http://schemas.openxmlformats.org/officeDocument/2006/relationships/image" Target="../media/image163.png"/><Relationship Id="rId26" Type="http://schemas.openxmlformats.org/officeDocument/2006/relationships/image" Target="../media/image171.png"/><Relationship Id="rId3" Type="http://schemas.openxmlformats.org/officeDocument/2006/relationships/image" Target="../media/image149.png"/><Relationship Id="rId21" Type="http://schemas.openxmlformats.org/officeDocument/2006/relationships/image" Target="../media/image166.png"/><Relationship Id="rId7" Type="http://schemas.microsoft.com/office/2007/relationships/hdphoto" Target="../media/hdphoto5.wdp"/><Relationship Id="rId12" Type="http://schemas.openxmlformats.org/officeDocument/2006/relationships/image" Target="../media/image157.png"/><Relationship Id="rId17" Type="http://schemas.openxmlformats.org/officeDocument/2006/relationships/image" Target="../media/image162.png"/><Relationship Id="rId25" Type="http://schemas.openxmlformats.org/officeDocument/2006/relationships/image" Target="../media/image170.png"/><Relationship Id="rId2" Type="http://schemas.openxmlformats.org/officeDocument/2006/relationships/image" Target="../media/image148.png"/><Relationship Id="rId16" Type="http://schemas.openxmlformats.org/officeDocument/2006/relationships/image" Target="../media/image161.png"/><Relationship Id="rId20" Type="http://schemas.openxmlformats.org/officeDocument/2006/relationships/image" Target="../media/image16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2.png"/><Relationship Id="rId11" Type="http://schemas.openxmlformats.org/officeDocument/2006/relationships/image" Target="../media/image156.png"/><Relationship Id="rId24" Type="http://schemas.openxmlformats.org/officeDocument/2006/relationships/image" Target="../media/image169.png"/><Relationship Id="rId5" Type="http://schemas.openxmlformats.org/officeDocument/2006/relationships/image" Target="../media/image151.png"/><Relationship Id="rId15" Type="http://schemas.openxmlformats.org/officeDocument/2006/relationships/image" Target="../media/image160.png"/><Relationship Id="rId23" Type="http://schemas.openxmlformats.org/officeDocument/2006/relationships/image" Target="../media/image168.png"/><Relationship Id="rId10" Type="http://schemas.openxmlformats.org/officeDocument/2006/relationships/image" Target="../media/image155.png"/><Relationship Id="rId19" Type="http://schemas.openxmlformats.org/officeDocument/2006/relationships/image" Target="../media/image164.png"/><Relationship Id="rId4" Type="http://schemas.openxmlformats.org/officeDocument/2006/relationships/image" Target="../media/image150.png"/><Relationship Id="rId9" Type="http://schemas.openxmlformats.org/officeDocument/2006/relationships/image" Target="../media/image154.png"/><Relationship Id="rId14" Type="http://schemas.openxmlformats.org/officeDocument/2006/relationships/image" Target="../media/image159.png"/><Relationship Id="rId22" Type="http://schemas.openxmlformats.org/officeDocument/2006/relationships/image" Target="../media/image167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3.png"/><Relationship Id="rId2" Type="http://schemas.openxmlformats.org/officeDocument/2006/relationships/image" Target="../media/image17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4.pn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1.png"/><Relationship Id="rId3" Type="http://schemas.openxmlformats.org/officeDocument/2006/relationships/image" Target="../media/image176.png"/><Relationship Id="rId7" Type="http://schemas.openxmlformats.org/officeDocument/2006/relationships/image" Target="../media/image180.png"/><Relationship Id="rId2" Type="http://schemas.openxmlformats.org/officeDocument/2006/relationships/image" Target="../media/image17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9.png"/><Relationship Id="rId5" Type="http://schemas.openxmlformats.org/officeDocument/2006/relationships/image" Target="../media/image178.png"/><Relationship Id="rId4" Type="http://schemas.openxmlformats.org/officeDocument/2006/relationships/image" Target="../media/image17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13" Type="http://schemas.openxmlformats.org/officeDocument/2006/relationships/image" Target="../media/image16.png"/><Relationship Id="rId18" Type="http://schemas.openxmlformats.org/officeDocument/2006/relationships/image" Target="../media/image2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12" Type="http://schemas.openxmlformats.org/officeDocument/2006/relationships/image" Target="../media/image15.png"/><Relationship Id="rId17" Type="http://schemas.openxmlformats.org/officeDocument/2006/relationships/image" Target="../media/image20.png"/><Relationship Id="rId2" Type="http://schemas.openxmlformats.org/officeDocument/2006/relationships/image" Target="../media/image5.png"/><Relationship Id="rId16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11" Type="http://schemas.openxmlformats.org/officeDocument/2006/relationships/image" Target="../media/image14.png"/><Relationship Id="rId5" Type="http://schemas.openxmlformats.org/officeDocument/2006/relationships/image" Target="../media/image8.png"/><Relationship Id="rId15" Type="http://schemas.openxmlformats.org/officeDocument/2006/relationships/image" Target="../media/image18.png"/><Relationship Id="rId10" Type="http://schemas.openxmlformats.org/officeDocument/2006/relationships/image" Target="../media/image13.png"/><Relationship Id="rId19" Type="http://schemas.openxmlformats.org/officeDocument/2006/relationships/image" Target="../media/image22.png"/><Relationship Id="rId4" Type="http://schemas.openxmlformats.org/officeDocument/2006/relationships/image" Target="../media/image7.png"/><Relationship Id="rId9" Type="http://schemas.openxmlformats.org/officeDocument/2006/relationships/image" Target="../media/image12.png"/><Relationship Id="rId14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openxmlformats.org/officeDocument/2006/relationships/image" Target="../media/image34.png"/><Relationship Id="rId18" Type="http://schemas.openxmlformats.org/officeDocument/2006/relationships/image" Target="../media/image39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12" Type="http://schemas.openxmlformats.org/officeDocument/2006/relationships/image" Target="../media/image33.png"/><Relationship Id="rId17" Type="http://schemas.openxmlformats.org/officeDocument/2006/relationships/image" Target="../media/image38.png"/><Relationship Id="rId2" Type="http://schemas.openxmlformats.org/officeDocument/2006/relationships/image" Target="../media/image23.png"/><Relationship Id="rId16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11" Type="http://schemas.openxmlformats.org/officeDocument/2006/relationships/image" Target="../media/image32.png"/><Relationship Id="rId5" Type="http://schemas.openxmlformats.org/officeDocument/2006/relationships/image" Target="../media/image26.png"/><Relationship Id="rId15" Type="http://schemas.openxmlformats.org/officeDocument/2006/relationships/image" Target="../media/image36.png"/><Relationship Id="rId10" Type="http://schemas.openxmlformats.org/officeDocument/2006/relationships/image" Target="../media/image31.png"/><Relationship Id="rId19" Type="http://schemas.openxmlformats.org/officeDocument/2006/relationships/image" Target="../media/image40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Relationship Id="rId14" Type="http://schemas.openxmlformats.org/officeDocument/2006/relationships/image" Target="../media/image3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png"/><Relationship Id="rId13" Type="http://schemas.openxmlformats.org/officeDocument/2006/relationships/image" Target="../media/image51.png"/><Relationship Id="rId18" Type="http://schemas.openxmlformats.org/officeDocument/2006/relationships/image" Target="../media/image56.png"/><Relationship Id="rId3" Type="http://schemas.openxmlformats.org/officeDocument/2006/relationships/image" Target="../media/image41.png"/><Relationship Id="rId21" Type="http://schemas.microsoft.com/office/2007/relationships/hdphoto" Target="../media/hdphoto1.wdp"/><Relationship Id="rId7" Type="http://schemas.openxmlformats.org/officeDocument/2006/relationships/image" Target="../media/image45.png"/><Relationship Id="rId12" Type="http://schemas.openxmlformats.org/officeDocument/2006/relationships/image" Target="../media/image50.png"/><Relationship Id="rId17" Type="http://schemas.openxmlformats.org/officeDocument/2006/relationships/image" Target="../media/image5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54.png"/><Relationship Id="rId20" Type="http://schemas.openxmlformats.org/officeDocument/2006/relationships/image" Target="../media/image5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4.png"/><Relationship Id="rId11" Type="http://schemas.openxmlformats.org/officeDocument/2006/relationships/image" Target="../media/image49.png"/><Relationship Id="rId5" Type="http://schemas.openxmlformats.org/officeDocument/2006/relationships/image" Target="../media/image43.png"/><Relationship Id="rId15" Type="http://schemas.openxmlformats.org/officeDocument/2006/relationships/image" Target="../media/image53.png"/><Relationship Id="rId10" Type="http://schemas.openxmlformats.org/officeDocument/2006/relationships/image" Target="../media/image48.png"/><Relationship Id="rId19" Type="http://schemas.openxmlformats.org/officeDocument/2006/relationships/image" Target="../media/image57.png"/><Relationship Id="rId4" Type="http://schemas.openxmlformats.org/officeDocument/2006/relationships/image" Target="../media/image42.png"/><Relationship Id="rId9" Type="http://schemas.openxmlformats.org/officeDocument/2006/relationships/image" Target="../media/image47.png"/><Relationship Id="rId14" Type="http://schemas.openxmlformats.org/officeDocument/2006/relationships/image" Target="../media/image5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7" Type="http://schemas.openxmlformats.org/officeDocument/2006/relationships/image" Target="../media/image64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3.png"/><Relationship Id="rId5" Type="http://schemas.openxmlformats.org/officeDocument/2006/relationships/image" Target="../media/image62.png"/><Relationship Id="rId4" Type="http://schemas.openxmlformats.org/officeDocument/2006/relationships/image" Target="../media/image61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0.png"/><Relationship Id="rId13" Type="http://schemas.openxmlformats.org/officeDocument/2006/relationships/image" Target="../media/image75.png"/><Relationship Id="rId18" Type="http://schemas.openxmlformats.org/officeDocument/2006/relationships/image" Target="../media/image80.png"/><Relationship Id="rId26" Type="http://schemas.openxmlformats.org/officeDocument/2006/relationships/image" Target="../media/image88.png"/><Relationship Id="rId3" Type="http://schemas.openxmlformats.org/officeDocument/2006/relationships/image" Target="../media/image66.png"/><Relationship Id="rId21" Type="http://schemas.openxmlformats.org/officeDocument/2006/relationships/image" Target="../media/image83.png"/><Relationship Id="rId7" Type="http://schemas.openxmlformats.org/officeDocument/2006/relationships/image" Target="../media/image69.png"/><Relationship Id="rId12" Type="http://schemas.openxmlformats.org/officeDocument/2006/relationships/image" Target="../media/image74.png"/><Relationship Id="rId17" Type="http://schemas.openxmlformats.org/officeDocument/2006/relationships/image" Target="../media/image79.png"/><Relationship Id="rId25" Type="http://schemas.openxmlformats.org/officeDocument/2006/relationships/image" Target="../media/image87.png"/><Relationship Id="rId2" Type="http://schemas.openxmlformats.org/officeDocument/2006/relationships/image" Target="../media/image65.png"/><Relationship Id="rId16" Type="http://schemas.openxmlformats.org/officeDocument/2006/relationships/image" Target="../media/image78.png"/><Relationship Id="rId20" Type="http://schemas.openxmlformats.org/officeDocument/2006/relationships/image" Target="../media/image8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8.png"/><Relationship Id="rId11" Type="http://schemas.openxmlformats.org/officeDocument/2006/relationships/image" Target="../media/image73.png"/><Relationship Id="rId24" Type="http://schemas.openxmlformats.org/officeDocument/2006/relationships/image" Target="../media/image86.png"/><Relationship Id="rId5" Type="http://schemas.openxmlformats.org/officeDocument/2006/relationships/image" Target="../media/image67.png"/><Relationship Id="rId15" Type="http://schemas.openxmlformats.org/officeDocument/2006/relationships/image" Target="../media/image77.png"/><Relationship Id="rId23" Type="http://schemas.openxmlformats.org/officeDocument/2006/relationships/image" Target="../media/image85.png"/><Relationship Id="rId10" Type="http://schemas.openxmlformats.org/officeDocument/2006/relationships/image" Target="../media/image72.png"/><Relationship Id="rId19" Type="http://schemas.openxmlformats.org/officeDocument/2006/relationships/image" Target="../media/image81.png"/><Relationship Id="rId4" Type="http://schemas.microsoft.com/office/2007/relationships/hdphoto" Target="../media/hdphoto2.wdp"/><Relationship Id="rId9" Type="http://schemas.openxmlformats.org/officeDocument/2006/relationships/image" Target="../media/image71.png"/><Relationship Id="rId14" Type="http://schemas.openxmlformats.org/officeDocument/2006/relationships/image" Target="../media/image76.png"/><Relationship Id="rId22" Type="http://schemas.openxmlformats.org/officeDocument/2006/relationships/image" Target="../media/image84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95.png"/><Relationship Id="rId13" Type="http://schemas.openxmlformats.org/officeDocument/2006/relationships/image" Target="../media/image100.png"/><Relationship Id="rId18" Type="http://schemas.openxmlformats.org/officeDocument/2006/relationships/image" Target="../media/image105.png"/><Relationship Id="rId3" Type="http://schemas.openxmlformats.org/officeDocument/2006/relationships/image" Target="../media/image90.png"/><Relationship Id="rId21" Type="http://schemas.openxmlformats.org/officeDocument/2006/relationships/image" Target="../media/image108.png"/><Relationship Id="rId7" Type="http://schemas.openxmlformats.org/officeDocument/2006/relationships/image" Target="../media/image94.png"/><Relationship Id="rId12" Type="http://schemas.openxmlformats.org/officeDocument/2006/relationships/image" Target="../media/image99.png"/><Relationship Id="rId17" Type="http://schemas.openxmlformats.org/officeDocument/2006/relationships/image" Target="../media/image104.png"/><Relationship Id="rId25" Type="http://schemas.openxmlformats.org/officeDocument/2006/relationships/image" Target="../media/image112.png"/><Relationship Id="rId2" Type="http://schemas.openxmlformats.org/officeDocument/2006/relationships/image" Target="../media/image89.png"/><Relationship Id="rId16" Type="http://schemas.openxmlformats.org/officeDocument/2006/relationships/image" Target="../media/image103.png"/><Relationship Id="rId20" Type="http://schemas.openxmlformats.org/officeDocument/2006/relationships/image" Target="../media/image10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3.png"/><Relationship Id="rId11" Type="http://schemas.openxmlformats.org/officeDocument/2006/relationships/image" Target="../media/image98.png"/><Relationship Id="rId24" Type="http://schemas.openxmlformats.org/officeDocument/2006/relationships/image" Target="../media/image111.png"/><Relationship Id="rId5" Type="http://schemas.openxmlformats.org/officeDocument/2006/relationships/image" Target="../media/image92.png"/><Relationship Id="rId15" Type="http://schemas.openxmlformats.org/officeDocument/2006/relationships/image" Target="../media/image102.png"/><Relationship Id="rId23" Type="http://schemas.openxmlformats.org/officeDocument/2006/relationships/image" Target="../media/image110.png"/><Relationship Id="rId10" Type="http://schemas.openxmlformats.org/officeDocument/2006/relationships/image" Target="../media/image97.png"/><Relationship Id="rId19" Type="http://schemas.openxmlformats.org/officeDocument/2006/relationships/image" Target="../media/image106.png"/><Relationship Id="rId4" Type="http://schemas.openxmlformats.org/officeDocument/2006/relationships/image" Target="../media/image91.png"/><Relationship Id="rId9" Type="http://schemas.openxmlformats.org/officeDocument/2006/relationships/image" Target="../media/image96.png"/><Relationship Id="rId14" Type="http://schemas.openxmlformats.org/officeDocument/2006/relationships/image" Target="../media/image101.png"/><Relationship Id="rId22" Type="http://schemas.openxmlformats.org/officeDocument/2006/relationships/image" Target="../media/image109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9.png"/><Relationship Id="rId3" Type="http://schemas.openxmlformats.org/officeDocument/2006/relationships/image" Target="../media/image114.png"/><Relationship Id="rId7" Type="http://schemas.openxmlformats.org/officeDocument/2006/relationships/image" Target="../media/image118.png"/><Relationship Id="rId2" Type="http://schemas.openxmlformats.org/officeDocument/2006/relationships/image" Target="../media/image1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7.png"/><Relationship Id="rId5" Type="http://schemas.openxmlformats.org/officeDocument/2006/relationships/image" Target="../media/image116.png"/><Relationship Id="rId4" Type="http://schemas.openxmlformats.org/officeDocument/2006/relationships/image" Target="../media/image1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7F42A854-0CF7-DA56-1FE2-3AB06974528A}"/>
              </a:ext>
            </a:extLst>
          </p:cNvPr>
          <p:cNvSpPr txBox="1"/>
          <p:nvPr/>
        </p:nvSpPr>
        <p:spPr>
          <a:xfrm>
            <a:off x="3786187" y="1076325"/>
            <a:ext cx="46196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>
                <a:latin typeface="Arial" panose="020B0604020202020204" pitchFamily="34" charset="0"/>
                <a:cs typeface="Arial" panose="020B0604020202020204" pitchFamily="34" charset="0"/>
              </a:rPr>
              <a:t>Unedited blot/gel images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E224D496-3AA2-E5AC-558B-4819732369A9}"/>
              </a:ext>
            </a:extLst>
          </p:cNvPr>
          <p:cNvSpPr txBox="1"/>
          <p:nvPr/>
        </p:nvSpPr>
        <p:spPr>
          <a:xfrm>
            <a:off x="781050" y="3059668"/>
            <a:ext cx="77724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The b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lue boxes represent figures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Figures.</a:t>
            </a:r>
          </a:p>
          <a:p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The red boxes represent the target bands.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023247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58B24432-4905-7F04-DB55-8A97C9F969D0}"/>
              </a:ext>
            </a:extLst>
          </p:cNvPr>
          <p:cNvSpPr txBox="1"/>
          <p:nvPr/>
        </p:nvSpPr>
        <p:spPr>
          <a:xfrm>
            <a:off x="0" y="0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S2D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9EB2EE75-AE73-9AA7-0F94-E172EDB4B4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12023" y="854629"/>
            <a:ext cx="3968115" cy="6858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1E0AED72-6AB0-7AE3-1946-97F6012C01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12023" y="2087281"/>
            <a:ext cx="3975100" cy="59055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900D2301-36F3-6A31-8DEB-28D6A2173B0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12023" y="3224683"/>
            <a:ext cx="4013200" cy="635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B3EF652F-4743-81DF-891B-160BC4F3DA0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12023" y="4307514"/>
            <a:ext cx="4013200" cy="5080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20302654-7D12-F516-B430-8418A254ACCD}"/>
              </a:ext>
            </a:extLst>
          </p:cNvPr>
          <p:cNvSpPr txBox="1"/>
          <p:nvPr/>
        </p:nvSpPr>
        <p:spPr>
          <a:xfrm>
            <a:off x="382606" y="805896"/>
            <a:ext cx="14914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BFCB8EE-905C-131D-4F6A-2A9D31DE9D35}"/>
              </a:ext>
            </a:extLst>
          </p:cNvPr>
          <p:cNvSpPr txBox="1"/>
          <p:nvPr/>
        </p:nvSpPr>
        <p:spPr>
          <a:xfrm>
            <a:off x="382606" y="2040714"/>
            <a:ext cx="14914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Collagen I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76196CB0-BD96-18C1-DE78-9C87D12F3662}"/>
              </a:ext>
            </a:extLst>
          </p:cNvPr>
          <p:cNvSpPr txBox="1"/>
          <p:nvPr/>
        </p:nvSpPr>
        <p:spPr>
          <a:xfrm>
            <a:off x="382606" y="3162932"/>
            <a:ext cx="14914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α-SMA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71FB3A8-0149-A3F5-40A6-7EDF29F1F69D}"/>
              </a:ext>
            </a:extLst>
          </p:cNvPr>
          <p:cNvSpPr txBox="1"/>
          <p:nvPr/>
        </p:nvSpPr>
        <p:spPr>
          <a:xfrm>
            <a:off x="382606" y="4324292"/>
            <a:ext cx="14914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995EB131-5364-E5D4-2361-54921014FFD6}"/>
              </a:ext>
            </a:extLst>
          </p:cNvPr>
          <p:cNvSpPr/>
          <p:nvPr/>
        </p:nvSpPr>
        <p:spPr>
          <a:xfrm>
            <a:off x="1377073" y="188884"/>
            <a:ext cx="4483100" cy="5948095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92905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0A03D816-3883-B43C-A28D-F6E21D4059DB}"/>
              </a:ext>
            </a:extLst>
          </p:cNvPr>
          <p:cNvSpPr txBox="1"/>
          <p:nvPr/>
        </p:nvSpPr>
        <p:spPr>
          <a:xfrm>
            <a:off x="0" y="0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S4A  left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D4EB95B9-6D1B-0CC1-CEDA-6E67D1131B0F}"/>
              </a:ext>
            </a:extLst>
          </p:cNvPr>
          <p:cNvSpPr txBox="1"/>
          <p:nvPr/>
        </p:nvSpPr>
        <p:spPr>
          <a:xfrm>
            <a:off x="0" y="2744598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S4C  right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823DB35-285F-E3D1-D3DC-83142F4754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80060" y="1360943"/>
            <a:ext cx="2000353" cy="615982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977F985E-B2A0-A486-6C09-E69C909F1D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80060" y="4156010"/>
            <a:ext cx="2038455" cy="69853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BB4A21EC-5C82-8339-DA20-056D410E135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11811" y="191632"/>
            <a:ext cx="1974951" cy="819192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74193780-014C-C211-1F39-3727FBD5F89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31146" y="3091869"/>
            <a:ext cx="1968601" cy="762039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9C1407A0-8DC2-17B7-36BD-519360A7D96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80060" y="3091869"/>
            <a:ext cx="1936850" cy="742988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AD8AF96D-B362-5C36-A846-D023F717AF3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29034" y="4156010"/>
            <a:ext cx="2070206" cy="736638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2A2FAAE2-CB1A-C20B-223C-AAD960B1206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129034" y="1360943"/>
            <a:ext cx="2038455" cy="730288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FB653D43-A440-DBC9-6E8B-B6E4D144DA9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31146" y="1360943"/>
            <a:ext cx="2025754" cy="57788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E661F9CF-32D6-EE66-F84D-F985CF136E6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731146" y="4156010"/>
            <a:ext cx="1987652" cy="58423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20EB068D-72FA-8D6C-1524-CC431AD5DF5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129034" y="3091869"/>
            <a:ext cx="1974951" cy="641383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CBD1B91E-59A1-04A9-0863-AF05FCFBE0C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129034" y="221012"/>
            <a:ext cx="1962251" cy="654084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6BAE61D4-466C-3674-6BBA-E8F70A6E757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731146" y="211861"/>
            <a:ext cx="2082907" cy="647733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C069442A-031D-CA3B-EC82-DB1022E102A6}"/>
              </a:ext>
            </a:extLst>
          </p:cNvPr>
          <p:cNvSpPr/>
          <p:nvPr/>
        </p:nvSpPr>
        <p:spPr>
          <a:xfrm>
            <a:off x="1574800" y="78327"/>
            <a:ext cx="2294739" cy="4814321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107393BE-97F4-A813-1325-E2A30DF4EAE6}"/>
              </a:ext>
            </a:extLst>
          </p:cNvPr>
          <p:cNvSpPr txBox="1"/>
          <p:nvPr/>
        </p:nvSpPr>
        <p:spPr>
          <a:xfrm>
            <a:off x="357761" y="307777"/>
            <a:ext cx="10634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SLC7A11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3411AADA-C245-F534-99EA-098096B4988D}"/>
              </a:ext>
            </a:extLst>
          </p:cNvPr>
          <p:cNvSpPr txBox="1"/>
          <p:nvPr/>
        </p:nvSpPr>
        <p:spPr>
          <a:xfrm>
            <a:off x="357761" y="1412579"/>
            <a:ext cx="10634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FD5212D-CA09-3120-FA9D-199FBE685DCB}"/>
              </a:ext>
            </a:extLst>
          </p:cNvPr>
          <p:cNvSpPr txBox="1"/>
          <p:nvPr/>
        </p:nvSpPr>
        <p:spPr>
          <a:xfrm>
            <a:off x="357761" y="3083005"/>
            <a:ext cx="10634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SLC7A11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834EED6B-3157-8A7C-F784-1BF68084EEBC}"/>
              </a:ext>
            </a:extLst>
          </p:cNvPr>
          <p:cNvSpPr txBox="1"/>
          <p:nvPr/>
        </p:nvSpPr>
        <p:spPr>
          <a:xfrm>
            <a:off x="357761" y="4187807"/>
            <a:ext cx="10634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781307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B93C098E-D65B-348A-296C-EA2835935A3C}"/>
              </a:ext>
            </a:extLst>
          </p:cNvPr>
          <p:cNvSpPr txBox="1"/>
          <p:nvPr/>
        </p:nvSpPr>
        <p:spPr>
          <a:xfrm>
            <a:off x="0" y="0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S4E  left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018FFA9B-0B6F-9C07-4A6A-40AC13334F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8046" y="773826"/>
            <a:ext cx="1346200" cy="4318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C21C6338-E041-F714-F251-9B71404742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58046" y="1926703"/>
            <a:ext cx="1377950" cy="4318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DBF6A0B4-D8C8-42C3-BDB4-033EB6DD1C7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52203" y="904009"/>
            <a:ext cx="1492250" cy="5080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5A26D41C-0411-16C3-76EC-034C8CFC673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652203" y="1926703"/>
            <a:ext cx="1320800" cy="47625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694DBE51-22FA-E9DD-6356-01C0952B3110}"/>
              </a:ext>
            </a:extLst>
          </p:cNvPr>
          <p:cNvSpPr txBox="1"/>
          <p:nvPr/>
        </p:nvSpPr>
        <p:spPr>
          <a:xfrm>
            <a:off x="5006782" y="0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S4E  right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45B1C91-2432-3EFC-0ABC-E62BB7161222}"/>
              </a:ext>
            </a:extLst>
          </p:cNvPr>
          <p:cNvSpPr txBox="1"/>
          <p:nvPr/>
        </p:nvSpPr>
        <p:spPr>
          <a:xfrm>
            <a:off x="25400" y="969818"/>
            <a:ext cx="8548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SP1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0443075-18FA-2C22-7E41-ADE8831C6B01}"/>
              </a:ext>
            </a:extLst>
          </p:cNvPr>
          <p:cNvSpPr txBox="1"/>
          <p:nvPr/>
        </p:nvSpPr>
        <p:spPr>
          <a:xfrm>
            <a:off x="25400" y="1932041"/>
            <a:ext cx="1094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8CCE998C-081C-D2FD-95A2-7FCB1E88A2F7}"/>
              </a:ext>
            </a:extLst>
          </p:cNvPr>
          <p:cNvSpPr txBox="1"/>
          <p:nvPr/>
        </p:nvSpPr>
        <p:spPr>
          <a:xfrm>
            <a:off x="5483805" y="969818"/>
            <a:ext cx="8548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SP1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4340AE8-B259-8CF0-0873-011E9F330600}"/>
              </a:ext>
            </a:extLst>
          </p:cNvPr>
          <p:cNvSpPr txBox="1"/>
          <p:nvPr/>
        </p:nvSpPr>
        <p:spPr>
          <a:xfrm>
            <a:off x="5506895" y="1932041"/>
            <a:ext cx="1094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300B2AB0-7334-4F69-3626-5356254C2598}"/>
              </a:ext>
            </a:extLst>
          </p:cNvPr>
          <p:cNvSpPr/>
          <p:nvPr/>
        </p:nvSpPr>
        <p:spPr>
          <a:xfrm>
            <a:off x="975831" y="454953"/>
            <a:ext cx="1731146" cy="2326348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0D28E4AE-053B-2E60-AB8A-5131A3279B5F}"/>
              </a:ext>
            </a:extLst>
          </p:cNvPr>
          <p:cNvSpPr/>
          <p:nvPr/>
        </p:nvSpPr>
        <p:spPr>
          <a:xfrm>
            <a:off x="6500331" y="467653"/>
            <a:ext cx="1731146" cy="2326348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CA85AF4-CEF9-9386-B773-B404472D68D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72831" y="1926703"/>
            <a:ext cx="1168460" cy="749339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F8D8701D-67BF-D1BB-8B8C-BA139080F87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99327" y="1926703"/>
            <a:ext cx="1346269" cy="76203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447CFE5B-41C2-4B60-81F5-B1029433B3B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489972" y="1926703"/>
            <a:ext cx="1219263" cy="609631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537E548E-4AB9-3344-3D1B-0EC901AB48B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907566" y="1926703"/>
            <a:ext cx="1403422" cy="527077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B3B642BC-C750-9288-DE5D-24C6EE65650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489972" y="904009"/>
            <a:ext cx="1251014" cy="768389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D7778B71-D246-419E-2BE7-51D8B0C45C2B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907566" y="904009"/>
            <a:ext cx="1282766" cy="742988"/>
          </a:xfrm>
          <a:prstGeom prst="rect">
            <a:avLst/>
          </a:prstGeom>
        </p:spPr>
      </p:pic>
      <p:sp>
        <p:nvSpPr>
          <p:cNvPr id="26" name="矩形: 单圆角 25">
            <a:extLst>
              <a:ext uri="{FF2B5EF4-FFF2-40B4-BE49-F238E27FC236}">
                <a16:creationId xmlns:a16="http://schemas.microsoft.com/office/drawing/2014/main" id="{5322FE13-1FD8-4F64-7E64-4E4D7089D38A}"/>
              </a:ext>
            </a:extLst>
          </p:cNvPr>
          <p:cNvSpPr/>
          <p:nvPr/>
        </p:nvSpPr>
        <p:spPr>
          <a:xfrm>
            <a:off x="9865621" y="1412009"/>
            <a:ext cx="1403422" cy="139954"/>
          </a:xfrm>
          <a:prstGeom prst="round1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874DF3F3-DF2B-8BE7-E6EB-63FDA93376FF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872831" y="773826"/>
            <a:ext cx="1231963" cy="1028753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7C14A669-943A-A5C4-BAF0-EF60E4A2C7C4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199327" y="773826"/>
            <a:ext cx="1390721" cy="850944"/>
          </a:xfrm>
          <a:prstGeom prst="rect">
            <a:avLst/>
          </a:prstGeom>
        </p:spPr>
      </p:pic>
      <p:sp>
        <p:nvSpPr>
          <p:cNvPr id="31" name="矩形: 单圆角 30">
            <a:extLst>
              <a:ext uri="{FF2B5EF4-FFF2-40B4-BE49-F238E27FC236}">
                <a16:creationId xmlns:a16="http://schemas.microsoft.com/office/drawing/2014/main" id="{12D52A82-8140-0C2B-040E-040E7C620C0A}"/>
              </a:ext>
            </a:extLst>
          </p:cNvPr>
          <p:cNvSpPr/>
          <p:nvPr/>
        </p:nvSpPr>
        <p:spPr>
          <a:xfrm>
            <a:off x="4106936" y="1412009"/>
            <a:ext cx="1584734" cy="173510"/>
          </a:xfrm>
          <a:prstGeom prst="round1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711613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D42596A1-3678-0AD7-6563-FBDF0F3CDF11}"/>
              </a:ext>
            </a:extLst>
          </p:cNvPr>
          <p:cNvSpPr txBox="1"/>
          <p:nvPr/>
        </p:nvSpPr>
        <p:spPr>
          <a:xfrm>
            <a:off x="-1" y="0"/>
            <a:ext cx="21131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S4J  upper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B7AC1D83-6494-F899-8745-158F9D0D37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7345" y="755271"/>
            <a:ext cx="1085850" cy="108585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DD9CE0D7-77DB-3691-5CCB-8F41FD809A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64100" y="755271"/>
            <a:ext cx="1073150" cy="92075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BB9BB8E-0CAE-F8B9-1391-88CEA870BD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27345" y="2157612"/>
            <a:ext cx="1047750" cy="40005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89C419C1-DE52-70D0-81DD-948E8AA6C11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64100" y="2157612"/>
            <a:ext cx="1009650" cy="46355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BBEABBF0-AD6B-A0DD-3160-FF2BBDA97F4E}"/>
              </a:ext>
            </a:extLst>
          </p:cNvPr>
          <p:cNvSpPr txBox="1"/>
          <p:nvPr/>
        </p:nvSpPr>
        <p:spPr>
          <a:xfrm>
            <a:off x="142832" y="3425591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S4C  lower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F7234C62-5737-6BA0-D588-68CF33974A5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27345" y="3876595"/>
            <a:ext cx="1016000" cy="6985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D0048FBF-E5DD-22DB-23A4-B76DC6ECA6E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64100" y="3876595"/>
            <a:ext cx="1041400" cy="70485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B1A1423F-B815-0C43-E986-43144A80EB5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27345" y="5247052"/>
            <a:ext cx="1028700" cy="74295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1E944EA0-8926-FB0A-CFBF-17295FBD3F0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264100" y="5241711"/>
            <a:ext cx="1022350" cy="59055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8D0C5222-FC2B-189D-BAA1-2B06CBE90AD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266423" y="762228"/>
            <a:ext cx="997001" cy="933498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AF29191A-0FC5-8A0D-E2A5-37A621D6574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554639" y="755271"/>
            <a:ext cx="971600" cy="889046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194DAA55-1D8B-2233-0E4E-180D3581FB5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266423" y="3883552"/>
            <a:ext cx="755689" cy="514376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C87E7798-20A7-2F67-31B4-7F108D8DC12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621916" y="3876595"/>
            <a:ext cx="1022403" cy="1022403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39AD4F4D-DBDA-578F-82E1-BE5159DB57BB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8886567" y="3876595"/>
            <a:ext cx="1073205" cy="1060505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2BB9795F-28AF-8E59-4F4F-5D6B98693DD2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554639" y="3876595"/>
            <a:ext cx="977950" cy="768389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227F73B2-B3A1-8F57-B3B2-9CAFD628F50D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7621916" y="755271"/>
            <a:ext cx="1003352" cy="1035103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01D30D57-4B64-5C16-9D98-E2A22A132134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8886567" y="755271"/>
            <a:ext cx="1041454" cy="876345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65560C59-A1F1-6424-90D4-D66D4D54978C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554639" y="2157612"/>
            <a:ext cx="1003352" cy="742988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7CF00324-2294-F555-1CB0-57935CD7C3AA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7621916" y="2157612"/>
            <a:ext cx="1041454" cy="596931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4616A12F-F030-6601-B1F1-A8E70C1DF829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8886567" y="2157612"/>
            <a:ext cx="952549" cy="546128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6F609602-80BD-D133-1AE3-84686D0CAA4A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2266423" y="5247052"/>
            <a:ext cx="1016052" cy="596931"/>
          </a:xfrm>
          <a:prstGeom prst="rect">
            <a:avLst/>
          </a:prstGeom>
        </p:spPr>
      </p:pic>
      <p:sp>
        <p:nvSpPr>
          <p:cNvPr id="8" name="Rectangle 10">
            <a:extLst>
              <a:ext uri="{FF2B5EF4-FFF2-40B4-BE49-F238E27FC236}">
                <a16:creationId xmlns:a16="http://schemas.microsoft.com/office/drawing/2014/main" id="{4505998D-E153-34BF-2372-BFFE822877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124" y="3994343"/>
            <a:ext cx="64079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SP1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2">
            <a:extLst>
              <a:ext uri="{FF2B5EF4-FFF2-40B4-BE49-F238E27FC236}">
                <a16:creationId xmlns:a16="http://schemas.microsoft.com/office/drawing/2014/main" id="{7CA760A4-8CAA-AD9E-CD01-B8CF72A631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82450" y="743196"/>
            <a:ext cx="76335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PX4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4">
            <a:extLst>
              <a:ext uri="{FF2B5EF4-FFF2-40B4-BE49-F238E27FC236}">
                <a16:creationId xmlns:a16="http://schemas.microsoft.com/office/drawing/2014/main" id="{FFAF18FB-D6DF-7CEC-6C9B-3E83DECF82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124" y="5152587"/>
            <a:ext cx="83388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PDH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10">
            <a:extLst>
              <a:ext uri="{FF2B5EF4-FFF2-40B4-BE49-F238E27FC236}">
                <a16:creationId xmlns:a16="http://schemas.microsoft.com/office/drawing/2014/main" id="{76260393-5980-E142-5DC1-2D7D625859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124" y="743196"/>
            <a:ext cx="833882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PX4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14">
            <a:extLst>
              <a:ext uri="{FF2B5EF4-FFF2-40B4-BE49-F238E27FC236}">
                <a16:creationId xmlns:a16="http://schemas.microsoft.com/office/drawing/2014/main" id="{A741516A-A757-ACEE-ABC1-FF94B7255A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124" y="2085911"/>
            <a:ext cx="83388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PDH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14">
            <a:extLst>
              <a:ext uri="{FF2B5EF4-FFF2-40B4-BE49-F238E27FC236}">
                <a16:creationId xmlns:a16="http://schemas.microsoft.com/office/drawing/2014/main" id="{9A45FA82-E603-888F-73B9-7502720543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82450" y="2085911"/>
            <a:ext cx="83388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PDH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10">
            <a:extLst>
              <a:ext uri="{FF2B5EF4-FFF2-40B4-BE49-F238E27FC236}">
                <a16:creationId xmlns:a16="http://schemas.microsoft.com/office/drawing/2014/main" id="{9BCC8003-E7E9-1C07-754C-0ABEC29A42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82450" y="3994343"/>
            <a:ext cx="64079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SP1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14">
            <a:extLst>
              <a:ext uri="{FF2B5EF4-FFF2-40B4-BE49-F238E27FC236}">
                <a16:creationId xmlns:a16="http://schemas.microsoft.com/office/drawing/2014/main" id="{3C358D25-588F-B68E-80CB-3E80BDB26B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82450" y="5152587"/>
            <a:ext cx="83388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PDH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42D3A6BA-7A3D-6B96-2969-07069ED583A8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2266423" y="2151868"/>
            <a:ext cx="1022403" cy="622332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F3B296DD-C08F-D2BC-208A-2A407FEBEEDF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560990" y="5261210"/>
            <a:ext cx="997001" cy="622332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6DB550BF-52EC-DC2F-6E54-B20358FC9572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7621916" y="5241711"/>
            <a:ext cx="1016052" cy="596931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E4A4C247-00E3-9C32-0D42-114203D33422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8886567" y="5241711"/>
            <a:ext cx="1016052" cy="571529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7E8C5990-A7DE-2D65-195E-7D7C6F998AA8}"/>
              </a:ext>
            </a:extLst>
          </p:cNvPr>
          <p:cNvSpPr/>
          <p:nvPr/>
        </p:nvSpPr>
        <p:spPr>
          <a:xfrm>
            <a:off x="6216333" y="4110182"/>
            <a:ext cx="1228176" cy="191938"/>
          </a:xfrm>
          <a:prstGeom prst="rect">
            <a:avLst/>
          </a:prstGeom>
          <a:noFill/>
          <a:ln>
            <a:solidFill>
              <a:srgbClr val="FF0000"/>
            </a:solidFill>
            <a:prstDash val="dash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DA3B2537-F9FD-8643-1CC7-DDDA719348FB}"/>
              </a:ext>
            </a:extLst>
          </p:cNvPr>
          <p:cNvSpPr/>
          <p:nvPr/>
        </p:nvSpPr>
        <p:spPr>
          <a:xfrm>
            <a:off x="975831" y="352472"/>
            <a:ext cx="1228032" cy="5845127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A546A3FF-D6DA-3DCD-99FB-A5EABEFF5042}"/>
              </a:ext>
            </a:extLst>
          </p:cNvPr>
          <p:cNvSpPr/>
          <p:nvPr/>
        </p:nvSpPr>
        <p:spPr>
          <a:xfrm>
            <a:off x="6193568" y="352473"/>
            <a:ext cx="1228032" cy="5647776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930476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FA30DC21-9E6E-6AD7-1D2A-3F274B7BBF5C}"/>
              </a:ext>
            </a:extLst>
          </p:cNvPr>
          <p:cNvSpPr txBox="1"/>
          <p:nvPr/>
        </p:nvSpPr>
        <p:spPr>
          <a:xfrm>
            <a:off x="0" y="0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S5A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0CBDB8C3-7BBD-51F8-C9F1-791CD69E39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34542" y="153888"/>
            <a:ext cx="2044805" cy="2324219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A5553347-CC2A-0877-0334-51B1611CFD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15399" y="2544649"/>
            <a:ext cx="2101958" cy="2197213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080E8761-608D-78E0-DFDE-2A4432DF8DD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15399" y="153888"/>
            <a:ext cx="1873346" cy="1962251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55F12723-B2B3-48CB-0911-9D02F339F639}"/>
              </a:ext>
            </a:extLst>
          </p:cNvPr>
          <p:cNvSpPr txBox="1"/>
          <p:nvPr/>
        </p:nvSpPr>
        <p:spPr>
          <a:xfrm>
            <a:off x="1112982" y="159996"/>
            <a:ext cx="101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GPX4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0C14187D-7278-0BE6-7D5F-C390715437AF}"/>
              </a:ext>
            </a:extLst>
          </p:cNvPr>
          <p:cNvSpPr txBox="1"/>
          <p:nvPr/>
        </p:nvSpPr>
        <p:spPr>
          <a:xfrm>
            <a:off x="1130589" y="2609078"/>
            <a:ext cx="101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SP1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7D745F6-678F-C9AE-E991-D09864CFDBCE}"/>
              </a:ext>
            </a:extLst>
          </p:cNvPr>
          <p:cNvSpPr txBox="1"/>
          <p:nvPr/>
        </p:nvSpPr>
        <p:spPr>
          <a:xfrm>
            <a:off x="5415342" y="153888"/>
            <a:ext cx="101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1B08B5F2-1E02-278C-EDA4-30273E8151E5}"/>
              </a:ext>
            </a:extLst>
          </p:cNvPr>
          <p:cNvSpPr/>
          <p:nvPr/>
        </p:nvSpPr>
        <p:spPr>
          <a:xfrm>
            <a:off x="1845136" y="0"/>
            <a:ext cx="2320463" cy="5647776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F6A7C5FB-6662-F40C-6B84-B916D40C5D50}"/>
              </a:ext>
            </a:extLst>
          </p:cNvPr>
          <p:cNvSpPr/>
          <p:nvPr/>
        </p:nvSpPr>
        <p:spPr>
          <a:xfrm>
            <a:off x="6496712" y="0"/>
            <a:ext cx="2320463" cy="2957886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481369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4BB2372A-9915-3F19-71C9-13B5F20A482C}"/>
              </a:ext>
            </a:extLst>
          </p:cNvPr>
          <p:cNvSpPr txBox="1"/>
          <p:nvPr/>
        </p:nvSpPr>
        <p:spPr>
          <a:xfrm>
            <a:off x="0" y="0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S8H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D60CE3E-FC5E-9E24-063C-88851EA97A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0940" y="649769"/>
            <a:ext cx="3968750" cy="108585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D19244EA-FC7C-08FC-6D7A-CB294A6F52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60940" y="2202838"/>
            <a:ext cx="4025900" cy="130175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DFD95B1D-D7E4-BB21-BCDB-AE58AA775E0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60940" y="3929130"/>
            <a:ext cx="4006850" cy="78105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82D3CEF-8A4D-7DA4-DA01-A1D58D394F2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60940" y="5312881"/>
            <a:ext cx="4070350" cy="5969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F6393F3F-2A63-2272-DA4F-01311E08F27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36210" y="649769"/>
            <a:ext cx="3733800" cy="11176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7D6F879C-8B94-F515-FA20-27F79B322CA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936210" y="2202838"/>
            <a:ext cx="4057650" cy="76835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40391C05-BC2A-E5A4-A217-447D4D53EF2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936209" y="3624330"/>
            <a:ext cx="3987800" cy="1174750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662F19F3-019B-F0C3-C70E-BBD7CF612117}"/>
              </a:ext>
            </a:extLst>
          </p:cNvPr>
          <p:cNvSpPr txBox="1"/>
          <p:nvPr/>
        </p:nvSpPr>
        <p:spPr>
          <a:xfrm>
            <a:off x="89777" y="633317"/>
            <a:ext cx="14914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D60F9EC-C54D-0B1B-7890-011C79827BC1}"/>
              </a:ext>
            </a:extLst>
          </p:cNvPr>
          <p:cNvSpPr txBox="1"/>
          <p:nvPr/>
        </p:nvSpPr>
        <p:spPr>
          <a:xfrm>
            <a:off x="63941" y="2190832"/>
            <a:ext cx="14914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Collagen I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C4BA889-B219-76C7-24D7-054AE28C0948}"/>
              </a:ext>
            </a:extLst>
          </p:cNvPr>
          <p:cNvSpPr txBox="1"/>
          <p:nvPr/>
        </p:nvSpPr>
        <p:spPr>
          <a:xfrm>
            <a:off x="96871" y="3817918"/>
            <a:ext cx="14914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α-SMA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9A5880A-766D-B02C-B3F5-AA0DACE4E167}"/>
              </a:ext>
            </a:extLst>
          </p:cNvPr>
          <p:cNvSpPr txBox="1"/>
          <p:nvPr/>
        </p:nvSpPr>
        <p:spPr>
          <a:xfrm>
            <a:off x="106068" y="5256774"/>
            <a:ext cx="14914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0">
            <a:extLst>
              <a:ext uri="{FF2B5EF4-FFF2-40B4-BE49-F238E27FC236}">
                <a16:creationId xmlns:a16="http://schemas.microsoft.com/office/drawing/2014/main" id="{18222A7B-77EF-BE02-83B8-48249F1311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56670" y="2190832"/>
            <a:ext cx="64079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SP1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12">
            <a:extLst>
              <a:ext uri="{FF2B5EF4-FFF2-40B4-BE49-F238E27FC236}">
                <a16:creationId xmlns:a16="http://schemas.microsoft.com/office/drawing/2014/main" id="{C09C1AA7-4C88-5858-E20E-0E9D07CD04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43993" y="3817918"/>
            <a:ext cx="746765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PX4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10">
            <a:extLst>
              <a:ext uri="{FF2B5EF4-FFF2-40B4-BE49-F238E27FC236}">
                <a16:creationId xmlns:a16="http://schemas.microsoft.com/office/drawing/2014/main" id="{A02F3B89-FA86-B73B-8FD7-04B8B12999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00143" y="633317"/>
            <a:ext cx="86344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HRF1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F4D1E3AC-F730-77FE-56B8-3BDEB4DCB6ED}"/>
              </a:ext>
            </a:extLst>
          </p:cNvPr>
          <p:cNvSpPr/>
          <p:nvPr/>
        </p:nvSpPr>
        <p:spPr>
          <a:xfrm>
            <a:off x="1147339" y="469900"/>
            <a:ext cx="4326361" cy="5647776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E46F2FB4-93BC-5A76-A60F-E20BC4B3F317}"/>
              </a:ext>
            </a:extLst>
          </p:cNvPr>
          <p:cNvSpPr/>
          <p:nvPr/>
        </p:nvSpPr>
        <p:spPr>
          <a:xfrm>
            <a:off x="6766929" y="469900"/>
            <a:ext cx="4326361" cy="4786874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8266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89C07A58-7504-39C3-DD15-899CD9DB022E}"/>
              </a:ext>
            </a:extLst>
          </p:cNvPr>
          <p:cNvSpPr txBox="1"/>
          <p:nvPr/>
        </p:nvSpPr>
        <p:spPr>
          <a:xfrm>
            <a:off x="0" y="0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1 F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DA1817BB-4731-0AB2-46AF-3B9A0D4594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5271" y="520367"/>
            <a:ext cx="3990975" cy="70485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DADA7A47-4B94-77E7-7A68-4423737AC96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15271" y="1736135"/>
            <a:ext cx="3990975" cy="74295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E8C0BA4-D4C9-4484-B192-B4587D9155F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15271" y="2879762"/>
            <a:ext cx="4006850" cy="733425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5DD25EAF-07BE-C6F1-4E96-FA52F2EF382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15271" y="3974441"/>
            <a:ext cx="4006850" cy="69215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A89A5351-B510-DC6D-DFF9-39EF17F9ACAB}"/>
              </a:ext>
            </a:extLst>
          </p:cNvPr>
          <p:cNvSpPr txBox="1"/>
          <p:nvPr/>
        </p:nvSpPr>
        <p:spPr>
          <a:xfrm>
            <a:off x="550385" y="548759"/>
            <a:ext cx="14914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229A0A6-8F63-F1B7-CBD6-AEAE4FA2EA83}"/>
              </a:ext>
            </a:extLst>
          </p:cNvPr>
          <p:cNvSpPr txBox="1"/>
          <p:nvPr/>
        </p:nvSpPr>
        <p:spPr>
          <a:xfrm>
            <a:off x="550385" y="1783577"/>
            <a:ext cx="14914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Collagen I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DC6B575-8000-76FB-A727-65EB75637629}"/>
              </a:ext>
            </a:extLst>
          </p:cNvPr>
          <p:cNvSpPr txBox="1"/>
          <p:nvPr/>
        </p:nvSpPr>
        <p:spPr>
          <a:xfrm>
            <a:off x="550385" y="2905795"/>
            <a:ext cx="14914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α-SMA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DEB3F7A-09FA-3C7F-1194-B89D87BAB383}"/>
              </a:ext>
            </a:extLst>
          </p:cNvPr>
          <p:cNvSpPr txBox="1"/>
          <p:nvPr/>
        </p:nvSpPr>
        <p:spPr>
          <a:xfrm>
            <a:off x="550385" y="4067155"/>
            <a:ext cx="14914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0CB67FDC-E0B1-3EE4-4C0B-5614825A3D65}"/>
              </a:ext>
            </a:extLst>
          </p:cNvPr>
          <p:cNvSpPr/>
          <p:nvPr/>
        </p:nvSpPr>
        <p:spPr>
          <a:xfrm>
            <a:off x="1562100" y="307777"/>
            <a:ext cx="4368800" cy="4670623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35244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3B4F6CD0-56FB-DE11-E1F4-B365655E7BB1}"/>
              </a:ext>
            </a:extLst>
          </p:cNvPr>
          <p:cNvSpPr txBox="1"/>
          <p:nvPr/>
        </p:nvSpPr>
        <p:spPr>
          <a:xfrm>
            <a:off x="-59822" y="0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3B  upper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4" name="图片 19">
            <a:extLst>
              <a:ext uri="{FF2B5EF4-FFF2-40B4-BE49-F238E27FC236}">
                <a16:creationId xmlns:a16="http://schemas.microsoft.com/office/drawing/2014/main" id="{EFEF00A6-71CE-5EB7-F6A7-9A6E0F14593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9443" y="374626"/>
            <a:ext cx="2070100" cy="6794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图片 20">
            <a:extLst>
              <a:ext uri="{FF2B5EF4-FFF2-40B4-BE49-F238E27FC236}">
                <a16:creationId xmlns:a16="http://schemas.microsoft.com/office/drawing/2014/main" id="{78312D71-0635-95E4-C8B8-4E115D5BE5F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9443" y="1227248"/>
            <a:ext cx="2070100" cy="946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0" name="图片 23">
            <a:extLst>
              <a:ext uri="{FF2B5EF4-FFF2-40B4-BE49-F238E27FC236}">
                <a16:creationId xmlns:a16="http://schemas.microsoft.com/office/drawing/2014/main" id="{A05A8A1F-1FC4-31DA-882C-FB5C4B74A45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9443" y="2288097"/>
            <a:ext cx="2082800" cy="571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9">
            <a:extLst>
              <a:ext uri="{FF2B5EF4-FFF2-40B4-BE49-F238E27FC236}">
                <a16:creationId xmlns:a16="http://schemas.microsoft.com/office/drawing/2014/main" id="{659F8A67-2730-99F1-DD37-0CF5D68154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1448" y="303312"/>
            <a:ext cx="18473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10">
            <a:extLst>
              <a:ext uri="{FF2B5EF4-FFF2-40B4-BE49-F238E27FC236}">
                <a16:creationId xmlns:a16="http://schemas.microsoft.com/office/drawing/2014/main" id="{CED69B36-4821-3D03-285F-CAFC50476F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068" y="381274"/>
            <a:ext cx="64079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SP1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12">
            <a:extLst>
              <a:ext uri="{FF2B5EF4-FFF2-40B4-BE49-F238E27FC236}">
                <a16:creationId xmlns:a16="http://schemas.microsoft.com/office/drawing/2014/main" id="{DD8C424F-C926-75B3-7DC2-9F1A3B5EEE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068" y="1378058"/>
            <a:ext cx="76335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PX4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4">
            <a:extLst>
              <a:ext uri="{FF2B5EF4-FFF2-40B4-BE49-F238E27FC236}">
                <a16:creationId xmlns:a16="http://schemas.microsoft.com/office/drawing/2014/main" id="{A043686C-6A40-1C8B-EBAD-810DE21263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068" y="2445314"/>
            <a:ext cx="83388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PDH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34DB974B-A0EB-2A0B-C09F-FC0D47D70BF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90855" y="1227248"/>
            <a:ext cx="1962251" cy="1016052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AECBA7E7-FA44-9552-9F52-6766E8E74FA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804418" y="1227248"/>
            <a:ext cx="2044805" cy="838243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C85AEB4D-4C75-619F-6BF8-53786484FE6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90855" y="374626"/>
            <a:ext cx="1955901" cy="679485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C89DFD83-B90C-0BB6-1896-CF34D8E95E3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90855" y="2288097"/>
            <a:ext cx="2013053" cy="508026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9288F84F-84DA-DA4D-E590-7AB8FE66B1E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804418" y="2288097"/>
            <a:ext cx="2013053" cy="508026"/>
          </a:xfrm>
          <a:prstGeom prst="rect">
            <a:avLst/>
          </a:prstGeom>
        </p:spPr>
      </p:pic>
      <p:pic>
        <p:nvPicPr>
          <p:cNvPr id="4" name="图片 21">
            <a:extLst>
              <a:ext uri="{FF2B5EF4-FFF2-40B4-BE49-F238E27FC236}">
                <a16:creationId xmlns:a16="http://schemas.microsoft.com/office/drawing/2014/main" id="{13DBB4E2-8E3B-B6BD-EA4E-9E2C5539EE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9443" y="3632452"/>
            <a:ext cx="2114550" cy="641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图片 22">
            <a:extLst>
              <a:ext uri="{FF2B5EF4-FFF2-40B4-BE49-F238E27FC236}">
                <a16:creationId xmlns:a16="http://schemas.microsoft.com/office/drawing/2014/main" id="{7AE2F92E-54C2-0BB9-C032-B1AD120C809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9443" y="4674203"/>
            <a:ext cx="2038350" cy="825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图片 24">
            <a:extLst>
              <a:ext uri="{FF2B5EF4-FFF2-40B4-BE49-F238E27FC236}">
                <a16:creationId xmlns:a16="http://schemas.microsoft.com/office/drawing/2014/main" id="{EA3A1B6B-E8A9-892E-2497-A35EF802C12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9443" y="6004138"/>
            <a:ext cx="2012950" cy="5270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7BB51210-8356-18E3-A271-234B700F7AD1}"/>
              </a:ext>
            </a:extLst>
          </p:cNvPr>
          <p:cNvSpPr/>
          <p:nvPr/>
        </p:nvSpPr>
        <p:spPr>
          <a:xfrm>
            <a:off x="1370377" y="3921720"/>
            <a:ext cx="2280932" cy="30777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zh-CN" altLang="en-US" sz="14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1">
            <a:extLst>
              <a:ext uri="{FF2B5EF4-FFF2-40B4-BE49-F238E27FC236}">
                <a16:creationId xmlns:a16="http://schemas.microsoft.com/office/drawing/2014/main" id="{6C868CBB-6671-89C9-AF95-4F60AF4F25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068" y="3836773"/>
            <a:ext cx="634358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SP1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3">
            <a:extLst>
              <a:ext uri="{FF2B5EF4-FFF2-40B4-BE49-F238E27FC236}">
                <a16:creationId xmlns:a16="http://schemas.microsoft.com/office/drawing/2014/main" id="{E0D396F3-5367-BA29-0E57-E1557250BC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068" y="4864508"/>
            <a:ext cx="66396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PX4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15">
            <a:extLst>
              <a:ext uri="{FF2B5EF4-FFF2-40B4-BE49-F238E27FC236}">
                <a16:creationId xmlns:a16="http://schemas.microsoft.com/office/drawing/2014/main" id="{FFBAB232-9467-BB3D-98B9-3C39B98FC5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068" y="6004138"/>
            <a:ext cx="839557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PDH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B825A350-BC7F-7307-0E10-E24561D3F614}"/>
              </a:ext>
            </a:extLst>
          </p:cNvPr>
          <p:cNvSpPr txBox="1"/>
          <p:nvPr/>
        </p:nvSpPr>
        <p:spPr>
          <a:xfrm>
            <a:off x="-44718" y="3137390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3B  lower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A0C234E1-711F-50C9-8137-3FABDFDF556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690855" y="6004138"/>
            <a:ext cx="1943200" cy="742988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BBC745E6-F9CC-9EC5-C583-2C31CCB8409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804418" y="6004138"/>
            <a:ext cx="2013053" cy="755689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2815A235-8E61-9BF1-F702-2FE60A9C33C4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804418" y="374626"/>
            <a:ext cx="1955901" cy="762039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016D26F3-EF94-0A02-9D36-7A48259EBB25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690855" y="3632452"/>
            <a:ext cx="2006703" cy="781090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84F501B1-41EA-580A-19DB-81A27BA2E8E5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804418" y="3632452"/>
            <a:ext cx="1911448" cy="831893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6129F174-51E8-7773-FD20-EC2DAFB44625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690855" y="4674203"/>
            <a:ext cx="1917799" cy="895396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A40B2257-33C5-F5FA-84C2-DF51ECF9CD3C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804418" y="4674203"/>
            <a:ext cx="1968601" cy="889046"/>
          </a:xfrm>
          <a:prstGeom prst="rect">
            <a:avLst/>
          </a:prstGeom>
        </p:spPr>
      </p:pic>
      <p:sp>
        <p:nvSpPr>
          <p:cNvPr id="15" name="矩形 14">
            <a:extLst>
              <a:ext uri="{FF2B5EF4-FFF2-40B4-BE49-F238E27FC236}">
                <a16:creationId xmlns:a16="http://schemas.microsoft.com/office/drawing/2014/main" id="{8F2B4CBC-09A0-A34C-7722-8F9319D349AE}"/>
              </a:ext>
            </a:extLst>
          </p:cNvPr>
          <p:cNvSpPr/>
          <p:nvPr/>
        </p:nvSpPr>
        <p:spPr>
          <a:xfrm>
            <a:off x="1376814" y="307777"/>
            <a:ext cx="2282290" cy="6439349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53357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3A2E8898-7A69-8003-7F42-3B2538A8CFFB}"/>
              </a:ext>
            </a:extLst>
          </p:cNvPr>
          <p:cNvSpPr txBox="1"/>
          <p:nvPr/>
        </p:nvSpPr>
        <p:spPr>
          <a:xfrm>
            <a:off x="0" y="0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3C  upper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9">
            <a:extLst>
              <a:ext uri="{FF2B5EF4-FFF2-40B4-BE49-F238E27FC236}">
                <a16:creationId xmlns:a16="http://schemas.microsoft.com/office/drawing/2014/main" id="{856ABA8D-5CC9-5F91-CEE7-1462BC6DD9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1448" y="303312"/>
            <a:ext cx="18473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0">
            <a:extLst>
              <a:ext uri="{FF2B5EF4-FFF2-40B4-BE49-F238E27FC236}">
                <a16:creationId xmlns:a16="http://schemas.microsoft.com/office/drawing/2014/main" id="{CF8F14FC-498A-310C-5B43-2E391E046B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104" y="643035"/>
            <a:ext cx="64079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SP1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2">
            <a:extLst>
              <a:ext uri="{FF2B5EF4-FFF2-40B4-BE49-F238E27FC236}">
                <a16:creationId xmlns:a16="http://schemas.microsoft.com/office/drawing/2014/main" id="{F74AD9A1-4030-BE4B-1C68-7161452407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-58838" y="1997459"/>
            <a:ext cx="76335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PX4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4">
            <a:extLst>
              <a:ext uri="{FF2B5EF4-FFF2-40B4-BE49-F238E27FC236}">
                <a16:creationId xmlns:a16="http://schemas.microsoft.com/office/drawing/2014/main" id="{B83ACA74-7230-E4FD-47EF-0D44394F91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-42252" y="3406973"/>
            <a:ext cx="83388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PDH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294F3A6F-1984-82F1-7DD4-EE383CE25B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5573" y="552335"/>
            <a:ext cx="990600" cy="431800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F6C22E1E-7647-ACC3-EB48-30F0E7FE79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5573" y="1938998"/>
            <a:ext cx="1054100" cy="723900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8AB58D50-FC47-0D4A-4A8F-BC1DF682D46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5573" y="3428536"/>
            <a:ext cx="1136650" cy="527050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BBC2C76A-93D5-9A3C-F6B6-FAE1B80D93E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09929" y="552335"/>
            <a:ext cx="996950" cy="511175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81DEB17B-BD44-75FE-6201-2C8CBBD33B1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809929" y="1938998"/>
            <a:ext cx="1015365" cy="647700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9344DE44-F9CA-9AF8-6200-978DD17182E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809929" y="3428536"/>
            <a:ext cx="1079500" cy="247650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42569F71-F965-297A-765E-64D06391D5F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147346" y="1938998"/>
            <a:ext cx="958899" cy="1054154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12774AEC-1C70-E764-0D9F-66EB25A282A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091282" y="552335"/>
            <a:ext cx="1143059" cy="876345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65B6264F-16EA-CF98-DCBF-062F24FA818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147346" y="552335"/>
            <a:ext cx="787440" cy="628682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2E624CA6-3EE1-8982-9763-2B094A4A361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469115" y="552335"/>
            <a:ext cx="806491" cy="596931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2ABDE906-76EC-6662-868E-A93D97CB138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9482627" y="552335"/>
            <a:ext cx="774740" cy="698536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AE526B5F-9D10-CE99-49FE-F9F4E9DAFB31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469115" y="1938998"/>
            <a:ext cx="825542" cy="806491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52BE5DB0-02DB-2E0D-6AFE-0332881C6B06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8091282" y="1938998"/>
            <a:ext cx="787440" cy="869995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9FF980A4-4F9D-CCAA-29BA-24867F6C9C34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9482627" y="1938998"/>
            <a:ext cx="914447" cy="825542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10E18E90-C628-56AD-77DB-C9D2BD6CFFF5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147346" y="3428536"/>
            <a:ext cx="1073205" cy="482625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1C97FA2F-5E5E-7D30-C53D-8CBB44BB233C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8091282" y="3428536"/>
            <a:ext cx="1028753" cy="476274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D25F529E-0FDC-142B-6282-4B35DBFC6134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469115" y="3428536"/>
            <a:ext cx="952549" cy="406421"/>
          </a:xfrm>
          <a:prstGeom prst="rect">
            <a:avLst/>
          </a:prstGeom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75587B0B-B574-4136-E071-3A7C25A67D84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9482627" y="3428536"/>
            <a:ext cx="933498" cy="577880"/>
          </a:xfrm>
          <a:prstGeom prst="rect">
            <a:avLst/>
          </a:prstGeom>
        </p:spPr>
      </p:pic>
      <p:sp>
        <p:nvSpPr>
          <p:cNvPr id="5" name="Rectangle 10">
            <a:extLst>
              <a:ext uri="{FF2B5EF4-FFF2-40B4-BE49-F238E27FC236}">
                <a16:creationId xmlns:a16="http://schemas.microsoft.com/office/drawing/2014/main" id="{49C936D7-517C-0C09-3D69-BAFAF7FE2B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64303" y="644433"/>
            <a:ext cx="64079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SP1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12">
            <a:extLst>
              <a:ext uri="{FF2B5EF4-FFF2-40B4-BE49-F238E27FC236}">
                <a16:creationId xmlns:a16="http://schemas.microsoft.com/office/drawing/2014/main" id="{0ABEC95C-6B03-819D-B989-A61AF69FDB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90361" y="1998857"/>
            <a:ext cx="76335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PX4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4">
            <a:extLst>
              <a:ext uri="{FF2B5EF4-FFF2-40B4-BE49-F238E27FC236}">
                <a16:creationId xmlns:a16="http://schemas.microsoft.com/office/drawing/2014/main" id="{9D9FC8F3-DD2D-FF8C-22C9-F7D472A900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06947" y="3408371"/>
            <a:ext cx="83388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PDH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976D4F14-1758-9DBD-6118-A3DCFBCAF489}"/>
              </a:ext>
            </a:extLst>
          </p:cNvPr>
          <p:cNvSpPr txBox="1"/>
          <p:nvPr/>
        </p:nvSpPr>
        <p:spPr>
          <a:xfrm>
            <a:off x="5419127" y="21151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3C  lower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95364FCD-CA90-A0BD-0974-25E7FA86DB5D}"/>
              </a:ext>
            </a:extLst>
          </p:cNvPr>
          <p:cNvSpPr/>
          <p:nvPr/>
        </p:nvSpPr>
        <p:spPr>
          <a:xfrm>
            <a:off x="791632" y="307777"/>
            <a:ext cx="1263334" cy="4670623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7987AEB5-08E9-03A2-1CF6-DFD927B68CD4}"/>
              </a:ext>
            </a:extLst>
          </p:cNvPr>
          <p:cNvSpPr/>
          <p:nvPr/>
        </p:nvSpPr>
        <p:spPr>
          <a:xfrm>
            <a:off x="6671732" y="307777"/>
            <a:ext cx="1263334" cy="4670623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90981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72E9B17F-0C25-BA8D-382B-C1E57CBB9ACD}"/>
              </a:ext>
            </a:extLst>
          </p:cNvPr>
          <p:cNvSpPr txBox="1"/>
          <p:nvPr/>
        </p:nvSpPr>
        <p:spPr>
          <a:xfrm>
            <a:off x="0" y="0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4A  left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7ECC539-D2E8-2A57-AAB7-53A26307C055}"/>
              </a:ext>
            </a:extLst>
          </p:cNvPr>
          <p:cNvSpPr txBox="1"/>
          <p:nvPr/>
        </p:nvSpPr>
        <p:spPr>
          <a:xfrm>
            <a:off x="5584798" y="-1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4A  right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0FFDE271-2576-DD79-7A29-2E63296560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51696" y="670666"/>
            <a:ext cx="1358900" cy="90170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67530195-650A-9D82-F0E7-042460DDD97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51696" y="2011510"/>
            <a:ext cx="1384300" cy="81915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BB444527-CF9E-B67F-F551-D1E5040C45D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51696" y="3460316"/>
            <a:ext cx="1365250" cy="5588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49DFEDE1-4B72-0E51-E8FE-214B301FD9A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82475" y="2011510"/>
            <a:ext cx="1295467" cy="1098606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ACAB22BD-77DE-9A75-2040-42602E36005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76208" y="2011510"/>
            <a:ext cx="1276416" cy="1047804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DDFAFE68-EBC3-875C-5798-688EDA33505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218239" y="2011510"/>
            <a:ext cx="1428823" cy="908097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7721F86C-6203-A8EA-ED92-E68B0CD3F63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807390" y="2011510"/>
            <a:ext cx="1333569" cy="1333569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5C54B395-F732-F1F6-212E-5A514FE23D4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582475" y="670666"/>
            <a:ext cx="1263715" cy="755689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B7BC9C8B-8774-958E-6B86-6F5D4EB153D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218239" y="670666"/>
            <a:ext cx="1428823" cy="584230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E21202C2-EB1C-FF87-0978-98C34BC132D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9807390" y="670666"/>
            <a:ext cx="1276416" cy="673135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CAEE3407-0C05-9247-E33F-5C567998919D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076208" y="670666"/>
            <a:ext cx="1289116" cy="736638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296C93B1-FE6E-DB42-11CD-655D0358A70C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582475" y="3460316"/>
            <a:ext cx="1378021" cy="565179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D5691887-CFCF-B37F-4114-9F237E3B2C22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076208" y="3460316"/>
            <a:ext cx="1384371" cy="558829"/>
          </a:xfrm>
          <a:prstGeom prst="rect">
            <a:avLst/>
          </a:prstGeom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97B8AD19-B5A9-2A95-4A07-B0332242D84A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8218239" y="3460316"/>
            <a:ext cx="1327218" cy="552478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3A37021A-F0E0-CADB-8607-9827EDA41404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9807390" y="3460316"/>
            <a:ext cx="1327218" cy="514376"/>
          </a:xfrm>
          <a:prstGeom prst="rect">
            <a:avLst/>
          </a:prstGeom>
        </p:spPr>
      </p:pic>
      <p:sp>
        <p:nvSpPr>
          <p:cNvPr id="13" name="Rectangle 10">
            <a:extLst>
              <a:ext uri="{FF2B5EF4-FFF2-40B4-BE49-F238E27FC236}">
                <a16:creationId xmlns:a16="http://schemas.microsoft.com/office/drawing/2014/main" id="{DD7EF2CA-1EE9-7824-4B55-5BFB462571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104" y="643035"/>
            <a:ext cx="64079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SP1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2">
            <a:extLst>
              <a:ext uri="{FF2B5EF4-FFF2-40B4-BE49-F238E27FC236}">
                <a16:creationId xmlns:a16="http://schemas.microsoft.com/office/drawing/2014/main" id="{9858F057-E9DC-7288-58CB-27445989C3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-58838" y="1997459"/>
            <a:ext cx="76335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PX4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14">
            <a:extLst>
              <a:ext uri="{FF2B5EF4-FFF2-40B4-BE49-F238E27FC236}">
                <a16:creationId xmlns:a16="http://schemas.microsoft.com/office/drawing/2014/main" id="{95C9967D-B4B4-13F2-5F15-36A0044BC2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-42252" y="3406973"/>
            <a:ext cx="83388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PDH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10">
            <a:extLst>
              <a:ext uri="{FF2B5EF4-FFF2-40B4-BE49-F238E27FC236}">
                <a16:creationId xmlns:a16="http://schemas.microsoft.com/office/drawing/2014/main" id="{9051246F-7F47-CB2E-AEB4-CA6601DC64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88134" y="636044"/>
            <a:ext cx="64079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SP1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tangle 12">
            <a:extLst>
              <a:ext uri="{FF2B5EF4-FFF2-40B4-BE49-F238E27FC236}">
                <a16:creationId xmlns:a16="http://schemas.microsoft.com/office/drawing/2014/main" id="{70DF49B5-62CD-A42A-2859-8D01D616D3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14192" y="1990468"/>
            <a:ext cx="76335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PX4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14">
            <a:extLst>
              <a:ext uri="{FF2B5EF4-FFF2-40B4-BE49-F238E27FC236}">
                <a16:creationId xmlns:a16="http://schemas.microsoft.com/office/drawing/2014/main" id="{F2ECCE10-1389-E021-9D40-964B96AE29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30778" y="3399982"/>
            <a:ext cx="83388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PDH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1953F65-CBEE-AF47-5818-22ADDC5F904D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6589256" y="670666"/>
            <a:ext cx="1314450" cy="85725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0EFC1062-E020-6EA9-A698-8A02D0AC6ADC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6621561" y="2011510"/>
            <a:ext cx="1320800" cy="93345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ABB4100C-83C9-FCB0-B38E-E0BD283ABD59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-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660906" y="3460316"/>
            <a:ext cx="1295400" cy="673100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F20F2E32-D5E4-2A3C-8984-FB8CC10F9833}"/>
              </a:ext>
            </a:extLst>
          </p:cNvPr>
          <p:cNvSpPr/>
          <p:nvPr/>
        </p:nvSpPr>
        <p:spPr>
          <a:xfrm>
            <a:off x="6545611" y="1178696"/>
            <a:ext cx="1428823" cy="241258"/>
          </a:xfrm>
          <a:prstGeom prst="rect">
            <a:avLst/>
          </a:prstGeom>
          <a:noFill/>
          <a:ln>
            <a:solidFill>
              <a:srgbClr val="FF0000"/>
            </a:solidFill>
            <a:prstDash val="dash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F545BA47-32EB-2C24-E4D1-EC00CF696F13}"/>
              </a:ext>
            </a:extLst>
          </p:cNvPr>
          <p:cNvSpPr/>
          <p:nvPr/>
        </p:nvSpPr>
        <p:spPr>
          <a:xfrm>
            <a:off x="955175" y="307777"/>
            <a:ext cx="1576429" cy="4670623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50042801-9A24-5530-4673-F2664FB8BFA9}"/>
              </a:ext>
            </a:extLst>
          </p:cNvPr>
          <p:cNvSpPr/>
          <p:nvPr/>
        </p:nvSpPr>
        <p:spPr>
          <a:xfrm>
            <a:off x="6530475" y="307777"/>
            <a:ext cx="1576429" cy="4670623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00135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EB95857-F9FE-01EC-4772-6D9B4C43CC2B}"/>
              </a:ext>
            </a:extLst>
          </p:cNvPr>
          <p:cNvSpPr txBox="1"/>
          <p:nvPr/>
        </p:nvSpPr>
        <p:spPr>
          <a:xfrm>
            <a:off x="0" y="0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4D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D307C81D-4D4F-E823-099D-7711143D47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69849" y="795691"/>
            <a:ext cx="1365320" cy="310531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BA019530-DE28-BA7F-116F-8D4DB88E849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22713" y="833793"/>
            <a:ext cx="1289116" cy="3067208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66ECA700-C25F-803A-4A0C-2C2723A38E1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5573" y="795691"/>
            <a:ext cx="1308167" cy="2844946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73A1EB3A-7D09-956B-4513-283AE6E493F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293025" y="795691"/>
            <a:ext cx="1378021" cy="3562533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89975AFE-0ED0-D8AA-5F48-379684F3D1F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77416" y="795691"/>
            <a:ext cx="1416123" cy="3194214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418F3D8F-5129-0E08-D6D7-8D08ACBC5D1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28335" y="795691"/>
            <a:ext cx="1308167" cy="3200564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A1F4798A-9E6A-4E89-29FC-4E9BEEEBB03B}"/>
              </a:ext>
            </a:extLst>
          </p:cNvPr>
          <p:cNvSpPr txBox="1"/>
          <p:nvPr/>
        </p:nvSpPr>
        <p:spPr>
          <a:xfrm>
            <a:off x="43536" y="786742"/>
            <a:ext cx="8220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GPX4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97A5CD37-3CB2-A64D-0479-51281510FD5C}"/>
              </a:ext>
            </a:extLst>
          </p:cNvPr>
          <p:cNvSpPr txBox="1"/>
          <p:nvPr/>
        </p:nvSpPr>
        <p:spPr>
          <a:xfrm>
            <a:off x="6307570" y="717182"/>
            <a:ext cx="8220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SP1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53913242-4E9F-040C-F526-289B6D1FD15F}"/>
              </a:ext>
            </a:extLst>
          </p:cNvPr>
          <p:cNvSpPr/>
          <p:nvPr/>
        </p:nvSpPr>
        <p:spPr>
          <a:xfrm>
            <a:off x="713875" y="307777"/>
            <a:ext cx="1576429" cy="4670623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F8D5163E-954A-93F1-1653-40197453AB3F}"/>
              </a:ext>
            </a:extLst>
          </p:cNvPr>
          <p:cNvSpPr/>
          <p:nvPr/>
        </p:nvSpPr>
        <p:spPr>
          <a:xfrm>
            <a:off x="7178175" y="307777"/>
            <a:ext cx="1576429" cy="4670623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55095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D0879432-A582-5EFC-B0BD-2EAB0C49062E}"/>
              </a:ext>
            </a:extLst>
          </p:cNvPr>
          <p:cNvSpPr txBox="1"/>
          <p:nvPr/>
        </p:nvSpPr>
        <p:spPr>
          <a:xfrm>
            <a:off x="6314320" y="223759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5D right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A7673783-C8BC-EBDB-59F9-6424EB19BD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86090" y="630202"/>
            <a:ext cx="1339850" cy="10795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DF139E9B-2B04-1B8D-671F-6E8453040E8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286090" y="2193904"/>
            <a:ext cx="1428750" cy="8128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4012AD09-985A-2F6A-1DD1-0008129A22E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86090" y="3477485"/>
            <a:ext cx="1416050" cy="889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D678C110-D371-9F07-E87C-8F6002C7573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286090" y="4960171"/>
            <a:ext cx="1365250" cy="43815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8AEDEF22-3A52-A5E9-DC40-CED383322FD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949142" y="630202"/>
            <a:ext cx="1263715" cy="730288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515BA8C8-9219-A98A-6CDD-EE993CE90B5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556274" y="630202"/>
            <a:ext cx="1333569" cy="679485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27D66826-B9BC-514F-F7B3-1EF527D87B5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949142" y="3477485"/>
            <a:ext cx="1378021" cy="800141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9DC13287-D46C-F8FF-B8F6-4DECC279821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556274" y="3477485"/>
            <a:ext cx="1339919" cy="838243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964C3EA0-21A8-1CCA-4CBD-1E7FB630315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949142" y="2193904"/>
            <a:ext cx="1238314" cy="603281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3C1B862B-34C2-5A24-9FEA-F496D894613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0556274" y="2193904"/>
            <a:ext cx="1320868" cy="584230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4EDA8B45-B51F-F6F3-0B32-62085C633249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949142" y="4960171"/>
            <a:ext cx="1346269" cy="539778"/>
          </a:xfrm>
          <a:prstGeom prst="rect">
            <a:avLst/>
          </a:prstGeom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id="{1BDA4376-BC54-7CE5-76D8-CE86186B282E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0556274" y="4960171"/>
            <a:ext cx="1384371" cy="488975"/>
          </a:xfrm>
          <a:prstGeom prst="rect">
            <a:avLst/>
          </a:prstGeom>
        </p:spPr>
      </p:pic>
      <p:sp>
        <p:nvSpPr>
          <p:cNvPr id="14" name="Rectangle 10">
            <a:extLst>
              <a:ext uri="{FF2B5EF4-FFF2-40B4-BE49-F238E27FC236}">
                <a16:creationId xmlns:a16="http://schemas.microsoft.com/office/drawing/2014/main" id="{877BE2D6-91A5-BB86-1ACC-A0C668F9EF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28490" y="2111869"/>
            <a:ext cx="64079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SP1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12">
            <a:extLst>
              <a:ext uri="{FF2B5EF4-FFF2-40B4-BE49-F238E27FC236}">
                <a16:creationId xmlns:a16="http://schemas.microsoft.com/office/drawing/2014/main" id="{DF530299-4D5A-1D85-C433-F60EC54903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54548" y="3466293"/>
            <a:ext cx="76335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PX4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14">
            <a:extLst>
              <a:ext uri="{FF2B5EF4-FFF2-40B4-BE49-F238E27FC236}">
                <a16:creationId xmlns:a16="http://schemas.microsoft.com/office/drawing/2014/main" id="{D5CB1B47-EEE8-5B8B-5A0C-DC28B61007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71134" y="4875807"/>
            <a:ext cx="83388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PDH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10">
            <a:extLst>
              <a:ext uri="{FF2B5EF4-FFF2-40B4-BE49-F238E27FC236}">
                <a16:creationId xmlns:a16="http://schemas.microsoft.com/office/drawing/2014/main" id="{BA8473FD-217C-ECA2-91B3-0FB9725D4F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30898" y="764079"/>
            <a:ext cx="86344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HRF1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AAFC8BF4-EE8A-C4CD-23EA-1468A6D3C82A}"/>
              </a:ext>
            </a:extLst>
          </p:cNvPr>
          <p:cNvSpPr txBox="1"/>
          <p:nvPr/>
        </p:nvSpPr>
        <p:spPr>
          <a:xfrm>
            <a:off x="327261" y="223759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5D  left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9943839C-2846-2C40-2453-6F44FD379249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402648" y="630203"/>
            <a:ext cx="1409700" cy="116205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78D4CF52-6D13-121E-B204-22F6E84E2B30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402648" y="2193905"/>
            <a:ext cx="1397000" cy="60325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A2882B9C-D6AC-306A-5977-8F4081A32BD7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402648" y="3477486"/>
            <a:ext cx="1397000" cy="102235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A08E65AE-8D34-CC47-AE0D-DD6F19904C7F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402648" y="4960172"/>
            <a:ext cx="1333500" cy="43815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D6C942ED-96A6-1BBA-31E9-474F22567B09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979927" y="630203"/>
            <a:ext cx="1333569" cy="685835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061E7FFE-878E-8827-9EDF-23FF9813FD5D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545811" y="630203"/>
            <a:ext cx="1276416" cy="1117657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9512499F-4F99-E4B6-A6F3-F371C992ED09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979927" y="3477486"/>
            <a:ext cx="1308167" cy="850944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D1F03A36-6C8C-3569-8D8B-9B8E6554AFB8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4545811" y="3477486"/>
            <a:ext cx="1327218" cy="819192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1EF79747-0162-B237-D2C2-830A022BBB61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4545811" y="2193905"/>
            <a:ext cx="1333569" cy="965250"/>
          </a:xfrm>
          <a:prstGeom prst="rect">
            <a:avLst/>
          </a:prstGeom>
        </p:spPr>
      </p:pic>
      <p:pic>
        <p:nvPicPr>
          <p:cNvPr id="64" name="图片 63">
            <a:extLst>
              <a:ext uri="{FF2B5EF4-FFF2-40B4-BE49-F238E27FC236}">
                <a16:creationId xmlns:a16="http://schemas.microsoft.com/office/drawing/2014/main" id="{2E6A6FC8-575A-20B4-E1D3-168BA0277AB1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2979927" y="4960172"/>
            <a:ext cx="1390721" cy="603281"/>
          </a:xfrm>
          <a:prstGeom prst="rect">
            <a:avLst/>
          </a:prstGeom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6E9A9D8E-A7F3-D549-8023-14D9782FD467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4545811" y="4960172"/>
            <a:ext cx="1365320" cy="622332"/>
          </a:xfrm>
          <a:prstGeom prst="rect">
            <a:avLst/>
          </a:prstGeom>
        </p:spPr>
      </p:pic>
      <p:sp>
        <p:nvSpPr>
          <p:cNvPr id="30" name="Rectangle 10">
            <a:extLst>
              <a:ext uri="{FF2B5EF4-FFF2-40B4-BE49-F238E27FC236}">
                <a16:creationId xmlns:a16="http://schemas.microsoft.com/office/drawing/2014/main" id="{9DB09D62-BAF2-83BD-0636-4B03BD7026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6775" y="2121657"/>
            <a:ext cx="64079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SP1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12">
            <a:extLst>
              <a:ext uri="{FF2B5EF4-FFF2-40B4-BE49-F238E27FC236}">
                <a16:creationId xmlns:a16="http://schemas.microsoft.com/office/drawing/2014/main" id="{46FC6456-7711-8450-DEFC-217CFF8D28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2833" y="3476081"/>
            <a:ext cx="76335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PX4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14">
            <a:extLst>
              <a:ext uri="{FF2B5EF4-FFF2-40B4-BE49-F238E27FC236}">
                <a16:creationId xmlns:a16="http://schemas.microsoft.com/office/drawing/2014/main" id="{E2443765-CB08-2644-57E2-AA968069B1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9419" y="4885595"/>
            <a:ext cx="83388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PDH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10">
            <a:extLst>
              <a:ext uri="{FF2B5EF4-FFF2-40B4-BE49-F238E27FC236}">
                <a16:creationId xmlns:a16="http://schemas.microsoft.com/office/drawing/2014/main" id="{0D5E709C-A558-2808-2C7C-70B13165E3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9183" y="773867"/>
            <a:ext cx="86344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HRF1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图片 40">
            <a:extLst>
              <a:ext uri="{FF2B5EF4-FFF2-40B4-BE49-F238E27FC236}">
                <a16:creationId xmlns:a16="http://schemas.microsoft.com/office/drawing/2014/main" id="{069AF3D1-DDE2-6A0D-2B07-8C376CD80431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2985123" y="2189431"/>
            <a:ext cx="1314518" cy="444523"/>
          </a:xfrm>
          <a:prstGeom prst="rect">
            <a:avLst/>
          </a:prstGeom>
        </p:spPr>
      </p:pic>
      <p:sp>
        <p:nvSpPr>
          <p:cNvPr id="33" name="矩形 32">
            <a:extLst>
              <a:ext uri="{FF2B5EF4-FFF2-40B4-BE49-F238E27FC236}">
                <a16:creationId xmlns:a16="http://schemas.microsoft.com/office/drawing/2014/main" id="{CF231E30-1D07-9B70-4475-292C2A281DF2}"/>
              </a:ext>
            </a:extLst>
          </p:cNvPr>
          <p:cNvSpPr/>
          <p:nvPr/>
        </p:nvSpPr>
        <p:spPr>
          <a:xfrm>
            <a:off x="1310775" y="531535"/>
            <a:ext cx="1576429" cy="5208865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96017C68-B7BC-0610-FA2A-3B01566F2524}"/>
              </a:ext>
            </a:extLst>
          </p:cNvPr>
          <p:cNvSpPr/>
          <p:nvPr/>
        </p:nvSpPr>
        <p:spPr>
          <a:xfrm>
            <a:off x="7216275" y="531535"/>
            <a:ext cx="1576429" cy="5208865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17D9C7CD-4E34-04BC-7EA8-3B8B76C7BF96}"/>
              </a:ext>
            </a:extLst>
          </p:cNvPr>
          <p:cNvSpPr/>
          <p:nvPr/>
        </p:nvSpPr>
        <p:spPr>
          <a:xfrm>
            <a:off x="7222626" y="2565587"/>
            <a:ext cx="1536813" cy="249845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736692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F4B83795-0F44-4B47-2F0E-37E96831BF46}"/>
              </a:ext>
            </a:extLst>
          </p:cNvPr>
          <p:cNvSpPr txBox="1"/>
          <p:nvPr/>
        </p:nvSpPr>
        <p:spPr>
          <a:xfrm>
            <a:off x="6256074" y="261970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5E right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BFD51090-8D2D-C744-A881-ED415741EB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13484" y="875005"/>
            <a:ext cx="1511300" cy="80645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6CE3409B-5800-745D-994B-EBFD644034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13484" y="2230866"/>
            <a:ext cx="1422400" cy="61595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4E99A248-24CD-AD39-4575-D954A84353C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13484" y="3600888"/>
            <a:ext cx="1365250" cy="14224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701CE454-D9F6-F351-D9B1-1C4D7B5F3F0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05095" y="5270217"/>
            <a:ext cx="1460500" cy="97790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A7377508-2AFC-A475-7F83-788B62121BB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99219" y="3600888"/>
            <a:ext cx="1282766" cy="768389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6F64E1F8-DB0C-76B6-BE22-AE320B92A25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471419" y="3600888"/>
            <a:ext cx="1295467" cy="793791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056720EE-4B18-3CBC-E4F4-06E5D55649D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471419" y="2230866"/>
            <a:ext cx="1365320" cy="1041454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9F85C629-F5B1-AA5B-3B3E-B0E607C610B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799219" y="2230866"/>
            <a:ext cx="1409772" cy="895396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67B445E8-6FFF-2F29-EAF5-C23C8D064AC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471419" y="875005"/>
            <a:ext cx="1339919" cy="863644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A514003A-3DA9-3341-AEFB-C00B9CF2495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799219" y="875005"/>
            <a:ext cx="1327218" cy="704886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F3560EFF-963D-19D2-6FB9-5C0DA8292EE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790830" y="5270217"/>
            <a:ext cx="1320868" cy="793791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B0A5EC05-ABBA-191C-BA4A-7BADA96CE9A1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0463030" y="5270217"/>
            <a:ext cx="1435174" cy="939848"/>
          </a:xfrm>
          <a:prstGeom prst="rect">
            <a:avLst/>
          </a:prstGeom>
        </p:spPr>
      </p:pic>
      <p:sp>
        <p:nvSpPr>
          <p:cNvPr id="4" name="Rectangle 10">
            <a:extLst>
              <a:ext uri="{FF2B5EF4-FFF2-40B4-BE49-F238E27FC236}">
                <a16:creationId xmlns:a16="http://schemas.microsoft.com/office/drawing/2014/main" id="{746BDE1B-E891-A754-959D-673A388F82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70244" y="2150080"/>
            <a:ext cx="64079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SP1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2">
            <a:extLst>
              <a:ext uri="{FF2B5EF4-FFF2-40B4-BE49-F238E27FC236}">
                <a16:creationId xmlns:a16="http://schemas.microsoft.com/office/drawing/2014/main" id="{5A8E1C84-698F-803B-2E5C-775F0C90FD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96302" y="3504504"/>
            <a:ext cx="76335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PX4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4">
            <a:extLst>
              <a:ext uri="{FF2B5EF4-FFF2-40B4-BE49-F238E27FC236}">
                <a16:creationId xmlns:a16="http://schemas.microsoft.com/office/drawing/2014/main" id="{0586FB71-6ED6-5E12-5309-16F6E9B911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12888" y="5123743"/>
            <a:ext cx="83388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PDH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10">
            <a:extLst>
              <a:ext uri="{FF2B5EF4-FFF2-40B4-BE49-F238E27FC236}">
                <a16:creationId xmlns:a16="http://schemas.microsoft.com/office/drawing/2014/main" id="{944C87C3-881A-0B8C-B161-3904607156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72652" y="802290"/>
            <a:ext cx="86344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HRF1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AC34F391-960B-8522-C43A-4314D49FC362}"/>
              </a:ext>
            </a:extLst>
          </p:cNvPr>
          <p:cNvSpPr txBox="1"/>
          <p:nvPr/>
        </p:nvSpPr>
        <p:spPr>
          <a:xfrm>
            <a:off x="-715" y="261970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5E left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D7C55507-2187-E41D-F05D-C72BC873891E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418591" y="875006"/>
            <a:ext cx="1358900" cy="90805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7EB0301B-355B-8E3A-4917-4BA9F062A8E0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418591" y="2230867"/>
            <a:ext cx="1377950" cy="6985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8D24677F-D48C-BB4C-690C-496F26A0EA9E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418591" y="3600889"/>
            <a:ext cx="1295400" cy="8001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DFB2730A-1735-39D0-EE50-A1D76F099731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410202" y="5270218"/>
            <a:ext cx="1365250" cy="736600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8019408B-6832-8E58-3DDD-4F9C4EAA4814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118953" y="3600889"/>
            <a:ext cx="1358970" cy="1085906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F592C36B-C65B-A238-BC60-71D48B770C2E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118953" y="2230867"/>
            <a:ext cx="1238314" cy="977950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2BCC5F81-F370-27B4-6750-96CB4923D5FE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767739" y="2230867"/>
            <a:ext cx="1314518" cy="1016052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8E05A321-E0A5-C62D-D664-1437668D02DA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767739" y="3600889"/>
            <a:ext cx="1289116" cy="844593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05F2F48F-0E64-8DE5-858B-E7ED94BC5D9C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3118953" y="875006"/>
            <a:ext cx="1225613" cy="749339"/>
          </a:xfrm>
          <a:prstGeom prst="rect">
            <a:avLst/>
          </a:prstGeom>
        </p:spPr>
      </p:pic>
      <p:sp>
        <p:nvSpPr>
          <p:cNvPr id="26" name="Rectangle 10">
            <a:extLst>
              <a:ext uri="{FF2B5EF4-FFF2-40B4-BE49-F238E27FC236}">
                <a16:creationId xmlns:a16="http://schemas.microsoft.com/office/drawing/2014/main" id="{35FCD105-7062-76FB-B025-82A56E3B06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0135" y="2143090"/>
            <a:ext cx="64079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SP1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12">
            <a:extLst>
              <a:ext uri="{FF2B5EF4-FFF2-40B4-BE49-F238E27FC236}">
                <a16:creationId xmlns:a16="http://schemas.microsoft.com/office/drawing/2014/main" id="{ABC45893-E5C4-C9ED-027B-655C9E1EC8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193" y="3497514"/>
            <a:ext cx="76335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PX4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14">
            <a:extLst>
              <a:ext uri="{FF2B5EF4-FFF2-40B4-BE49-F238E27FC236}">
                <a16:creationId xmlns:a16="http://schemas.microsoft.com/office/drawing/2014/main" id="{622327A4-24AC-CB46-7866-034E13F51A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779" y="5116753"/>
            <a:ext cx="83388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PDH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10">
            <a:extLst>
              <a:ext uri="{FF2B5EF4-FFF2-40B4-BE49-F238E27FC236}">
                <a16:creationId xmlns:a16="http://schemas.microsoft.com/office/drawing/2014/main" id="{615D96AE-18BF-BBB8-66E9-76F3E66CD1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2543" y="795300"/>
            <a:ext cx="86344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HRF1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图片 41">
            <a:extLst>
              <a:ext uri="{FF2B5EF4-FFF2-40B4-BE49-F238E27FC236}">
                <a16:creationId xmlns:a16="http://schemas.microsoft.com/office/drawing/2014/main" id="{739E9013-82A5-A844-5586-E47CCFACDEB0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4745252" y="5270218"/>
            <a:ext cx="1390721" cy="584230"/>
          </a:xfrm>
          <a:prstGeom prst="rect">
            <a:avLst/>
          </a:prstGeom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B215D345-FDB4-AF7E-68D8-C0AC7378FE82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128623" y="5270218"/>
            <a:ext cx="1358970" cy="628682"/>
          </a:xfrm>
          <a:prstGeom prst="rect">
            <a:avLst/>
          </a:prstGeom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0A64EDBC-B5DB-9919-3B6C-C291A9912F2D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4773827" y="866353"/>
            <a:ext cx="1333569" cy="1079555"/>
          </a:xfrm>
          <a:prstGeom prst="rect">
            <a:avLst/>
          </a:prstGeom>
        </p:spPr>
      </p:pic>
      <p:sp>
        <p:nvSpPr>
          <p:cNvPr id="28" name="矩形 27">
            <a:extLst>
              <a:ext uri="{FF2B5EF4-FFF2-40B4-BE49-F238E27FC236}">
                <a16:creationId xmlns:a16="http://schemas.microsoft.com/office/drawing/2014/main" id="{FBA897C5-5689-6E83-37C8-186AE068598B}"/>
              </a:ext>
            </a:extLst>
          </p:cNvPr>
          <p:cNvSpPr/>
          <p:nvPr/>
        </p:nvSpPr>
        <p:spPr>
          <a:xfrm>
            <a:off x="1296169" y="531535"/>
            <a:ext cx="1616436" cy="5678530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27729D70-CB9C-0878-D098-BC513C1779F3}"/>
              </a:ext>
            </a:extLst>
          </p:cNvPr>
          <p:cNvSpPr/>
          <p:nvPr/>
        </p:nvSpPr>
        <p:spPr>
          <a:xfrm>
            <a:off x="7036569" y="531534"/>
            <a:ext cx="1616436" cy="5881965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561814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23329F79-7C7A-18C1-1C72-13009C88EF3A}"/>
              </a:ext>
            </a:extLst>
          </p:cNvPr>
          <p:cNvSpPr txBox="1"/>
          <p:nvPr/>
        </p:nvSpPr>
        <p:spPr>
          <a:xfrm>
            <a:off x="-715" y="261970"/>
            <a:ext cx="1731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 6G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173C2DD-3AC4-3DD5-1CA4-B2DCAAD9A0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82787" y="492762"/>
            <a:ext cx="4064000" cy="110490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10A940B3-234C-A250-3AA2-1B7C3E8200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82787" y="2025895"/>
            <a:ext cx="4038600" cy="10922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742A4E1E-00D1-373A-1E62-46370689F8E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82787" y="3532932"/>
            <a:ext cx="4006850" cy="81915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A481D8DD-EA46-91D4-0DFB-53EF69F861B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82787" y="5026288"/>
            <a:ext cx="4089400" cy="6985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996846A6-70B8-349C-FA3A-A3820C85E9A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019762" y="492762"/>
            <a:ext cx="3892550" cy="11049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90A87865-EBB1-18E0-7DF4-0620CA3AB38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994362" y="2025895"/>
            <a:ext cx="3943350" cy="83185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4A488946-9316-57F6-DFD8-6B7C93BF196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994362" y="3429000"/>
            <a:ext cx="4121150" cy="1073150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DC44BD69-ECCC-F6C5-BE4C-9792D769D0D5}"/>
              </a:ext>
            </a:extLst>
          </p:cNvPr>
          <p:cNvSpPr txBox="1"/>
          <p:nvPr/>
        </p:nvSpPr>
        <p:spPr>
          <a:xfrm>
            <a:off x="977597" y="656216"/>
            <a:ext cx="14914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7476380-E5AB-2F0D-8C42-B55641CB61D2}"/>
              </a:ext>
            </a:extLst>
          </p:cNvPr>
          <p:cNvSpPr txBox="1"/>
          <p:nvPr/>
        </p:nvSpPr>
        <p:spPr>
          <a:xfrm>
            <a:off x="951761" y="2213731"/>
            <a:ext cx="14914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Collagen I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16F0A9E-B576-D6BA-8407-39F2B0C50EC4}"/>
              </a:ext>
            </a:extLst>
          </p:cNvPr>
          <p:cNvSpPr txBox="1"/>
          <p:nvPr/>
        </p:nvSpPr>
        <p:spPr>
          <a:xfrm>
            <a:off x="984691" y="3840817"/>
            <a:ext cx="14914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α-SMA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0">
            <a:extLst>
              <a:ext uri="{FF2B5EF4-FFF2-40B4-BE49-F238E27FC236}">
                <a16:creationId xmlns:a16="http://schemas.microsoft.com/office/drawing/2014/main" id="{A437BAB9-89E4-A0AC-3E1C-5277AEB87F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45380" y="2241970"/>
            <a:ext cx="64079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SP1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2">
            <a:extLst>
              <a:ext uri="{FF2B5EF4-FFF2-40B4-BE49-F238E27FC236}">
                <a16:creationId xmlns:a16="http://schemas.microsoft.com/office/drawing/2014/main" id="{38E672DA-98EF-89E8-A0DA-8C7DF434CF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32703" y="3840817"/>
            <a:ext cx="746765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PX4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0">
            <a:extLst>
              <a:ext uri="{FF2B5EF4-FFF2-40B4-BE49-F238E27FC236}">
                <a16:creationId xmlns:a16="http://schemas.microsoft.com/office/drawing/2014/main" id="{484D52B3-DD0C-7498-A59E-AD432F6B85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88853" y="684455"/>
            <a:ext cx="86344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HRF1</a:t>
            </a:r>
            <a:r>
              <a:rPr kumimoji="0" lang="en-US" altLang="zh-CN" sz="14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</a:t>
            </a:r>
            <a:endParaRPr kumimoji="0" lang="en-US" altLang="zh-CN" sz="14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3E81FF7-983B-3DD1-2538-67A942ECEC71}"/>
              </a:ext>
            </a:extLst>
          </p:cNvPr>
          <p:cNvSpPr txBox="1"/>
          <p:nvPr/>
        </p:nvSpPr>
        <p:spPr>
          <a:xfrm>
            <a:off x="952762" y="5160018"/>
            <a:ext cx="14914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1F542A8B-032C-96C8-1356-21AA9280ABC3}"/>
              </a:ext>
            </a:extLst>
          </p:cNvPr>
          <p:cNvSpPr/>
          <p:nvPr/>
        </p:nvSpPr>
        <p:spPr>
          <a:xfrm>
            <a:off x="2019300" y="261970"/>
            <a:ext cx="4483100" cy="5948095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D8A375FC-5CED-1394-AA3E-31BBCEF3648B}"/>
              </a:ext>
            </a:extLst>
          </p:cNvPr>
          <p:cNvSpPr/>
          <p:nvPr/>
        </p:nvSpPr>
        <p:spPr>
          <a:xfrm>
            <a:off x="7708900" y="261970"/>
            <a:ext cx="4483100" cy="4514983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23009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57</TotalTime>
  <Words>179</Words>
  <Application>Microsoft Office PowerPoint</Application>
  <PresentationFormat>宽屏</PresentationFormat>
  <Paragraphs>104</Paragraphs>
  <Slides>15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5</vt:i4>
      </vt:variant>
    </vt:vector>
  </HeadingPairs>
  <TitlesOfParts>
    <vt:vector size="1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程 德敏</dc:creator>
  <cp:lastModifiedBy>Administrator</cp:lastModifiedBy>
  <cp:revision>33</cp:revision>
  <dcterms:created xsi:type="dcterms:W3CDTF">2022-08-31T14:08:12Z</dcterms:created>
  <dcterms:modified xsi:type="dcterms:W3CDTF">2022-09-29T07:42:35Z</dcterms:modified>
</cp:coreProperties>
</file>